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6" r:id="rId2"/>
  </p:sldIdLst>
  <p:sldSz cx="12623800" cy="12185650"/>
  <p:notesSz cx="6858000" cy="9144000"/>
  <p:defaultTextStyle>
    <a:defPPr>
      <a:defRPr lang="en-US"/>
    </a:defPPr>
    <a:lvl1pPr marL="0" algn="l" defTabSz="45716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62" algn="l" defTabSz="45716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323" algn="l" defTabSz="45716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485" algn="l" defTabSz="45716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646" algn="l" defTabSz="45716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808" algn="l" defTabSz="45716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2969" algn="l" defTabSz="45716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131" algn="l" defTabSz="45716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293" algn="l" defTabSz="45716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A64C15F-44D8-D341-BE5C-5AE8521C82D9}" v="8" dt="2024-04-01T13:16:27.44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9643"/>
    <p:restoredTop sz="90813"/>
  </p:normalViewPr>
  <p:slideViewPr>
    <p:cSldViewPr snapToGrid="0">
      <p:cViewPr>
        <p:scale>
          <a:sx n="115" d="100"/>
          <a:sy n="115" d="100"/>
        </p:scale>
        <p:origin x="1200" y="-20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İZEM GÜLPINAR" userId="565a83b7-4207-49a5-b85b-de32e059dfa9" providerId="ADAL" clId="{3A64C15F-44D8-D341-BE5C-5AE8521C82D9}"/>
    <pc:docChg chg="undo redo custSel modSld modMainMaster">
      <pc:chgData name="GİZEM GÜLPINAR" userId="565a83b7-4207-49a5-b85b-de32e059dfa9" providerId="ADAL" clId="{3A64C15F-44D8-D341-BE5C-5AE8521C82D9}" dt="2024-04-01T13:45:52.424" v="743" actId="14100"/>
      <pc:docMkLst>
        <pc:docMk/>
      </pc:docMkLst>
      <pc:sldChg chg="addSp delSp modSp mod modNotesTx">
        <pc:chgData name="GİZEM GÜLPINAR" userId="565a83b7-4207-49a5-b85b-de32e059dfa9" providerId="ADAL" clId="{3A64C15F-44D8-D341-BE5C-5AE8521C82D9}" dt="2024-04-01T13:45:52.424" v="743" actId="14100"/>
        <pc:sldMkLst>
          <pc:docMk/>
          <pc:sldMk cId="2676113575" sldId="256"/>
        </pc:sldMkLst>
        <pc:spChg chg="del mod">
          <ac:chgData name="GİZEM GÜLPINAR" userId="565a83b7-4207-49a5-b85b-de32e059dfa9" providerId="ADAL" clId="{3A64C15F-44D8-D341-BE5C-5AE8521C82D9}" dt="2024-04-01T13:07:52.407" v="476" actId="478"/>
          <ac:spMkLst>
            <pc:docMk/>
            <pc:sldMk cId="2676113575" sldId="256"/>
            <ac:spMk id="2" creationId="{3F91CCE7-720B-7C01-08D5-D8FAE3EA4EE1}"/>
          </ac:spMkLst>
        </pc:spChg>
        <pc:spChg chg="mod">
          <ac:chgData name="GİZEM GÜLPINAR" userId="565a83b7-4207-49a5-b85b-de32e059dfa9" providerId="ADAL" clId="{3A64C15F-44D8-D341-BE5C-5AE8521C82D9}" dt="2024-04-01T13:41:05.357" v="675" actId="20577"/>
          <ac:spMkLst>
            <pc:docMk/>
            <pc:sldMk cId="2676113575" sldId="256"/>
            <ac:spMk id="4" creationId="{EA513D34-87ED-AF7F-BD9B-2F60A4DEEBA6}"/>
          </ac:spMkLst>
        </pc:spChg>
        <pc:spChg chg="mod">
          <ac:chgData name="GİZEM GÜLPINAR" userId="565a83b7-4207-49a5-b85b-de32e059dfa9" providerId="ADAL" clId="{3A64C15F-44D8-D341-BE5C-5AE8521C82D9}" dt="2024-04-01T13:45:52.424" v="743" actId="14100"/>
          <ac:spMkLst>
            <pc:docMk/>
            <pc:sldMk cId="2676113575" sldId="256"/>
            <ac:spMk id="5" creationId="{E5AEB965-E841-8063-B4E2-47E98F92F0FB}"/>
          </ac:spMkLst>
        </pc:spChg>
        <pc:spChg chg="mod">
          <ac:chgData name="GİZEM GÜLPINAR" userId="565a83b7-4207-49a5-b85b-de32e059dfa9" providerId="ADAL" clId="{3A64C15F-44D8-D341-BE5C-5AE8521C82D9}" dt="2024-04-01T13:45:42.323" v="742" actId="20577"/>
          <ac:spMkLst>
            <pc:docMk/>
            <pc:sldMk cId="2676113575" sldId="256"/>
            <ac:spMk id="6" creationId="{7F32CDFE-EB59-0769-22ED-28FF95A455EE}"/>
          </ac:spMkLst>
        </pc:spChg>
        <pc:spChg chg="mod">
          <ac:chgData name="GİZEM GÜLPINAR" userId="565a83b7-4207-49a5-b85b-de32e059dfa9" providerId="ADAL" clId="{3A64C15F-44D8-D341-BE5C-5AE8521C82D9}" dt="2024-04-01T13:44:11.879" v="727" actId="20577"/>
          <ac:spMkLst>
            <pc:docMk/>
            <pc:sldMk cId="2676113575" sldId="256"/>
            <ac:spMk id="7" creationId="{B677734E-4964-4F2A-3B3F-04FDFAA64639}"/>
          </ac:spMkLst>
        </pc:spChg>
        <pc:spChg chg="mod">
          <ac:chgData name="GİZEM GÜLPINAR" userId="565a83b7-4207-49a5-b85b-de32e059dfa9" providerId="ADAL" clId="{3A64C15F-44D8-D341-BE5C-5AE8521C82D9}" dt="2024-04-01T13:45:01.440" v="736" actId="1076"/>
          <ac:spMkLst>
            <pc:docMk/>
            <pc:sldMk cId="2676113575" sldId="256"/>
            <ac:spMk id="8" creationId="{7042FB28-0191-582F-0428-CCBDBE2A13F1}"/>
          </ac:spMkLst>
        </pc:spChg>
        <pc:spChg chg="mod">
          <ac:chgData name="GİZEM GÜLPINAR" userId="565a83b7-4207-49a5-b85b-de32e059dfa9" providerId="ADAL" clId="{3A64C15F-44D8-D341-BE5C-5AE8521C82D9}" dt="2024-04-01T13:39:22.603" v="647" actId="14100"/>
          <ac:spMkLst>
            <pc:docMk/>
            <pc:sldMk cId="2676113575" sldId="256"/>
            <ac:spMk id="9" creationId="{7F194D48-8841-8AE3-649B-83761F4F1487}"/>
          </ac:spMkLst>
        </pc:spChg>
        <pc:spChg chg="mod">
          <ac:chgData name="GİZEM GÜLPINAR" userId="565a83b7-4207-49a5-b85b-de32e059dfa9" providerId="ADAL" clId="{3A64C15F-44D8-D341-BE5C-5AE8521C82D9}" dt="2024-04-01T13:01:07.136" v="386" actId="255"/>
          <ac:spMkLst>
            <pc:docMk/>
            <pc:sldMk cId="2676113575" sldId="256"/>
            <ac:spMk id="11" creationId="{B2D2C206-EF3D-3CFA-5A96-3F23629B1735}"/>
          </ac:spMkLst>
        </pc:spChg>
        <pc:spChg chg="mod">
          <ac:chgData name="GİZEM GÜLPINAR" userId="565a83b7-4207-49a5-b85b-de32e059dfa9" providerId="ADAL" clId="{3A64C15F-44D8-D341-BE5C-5AE8521C82D9}" dt="2024-04-01T13:00:54.782" v="383" actId="403"/>
          <ac:spMkLst>
            <pc:docMk/>
            <pc:sldMk cId="2676113575" sldId="256"/>
            <ac:spMk id="12" creationId="{985814F7-8AA5-2F43-59E2-A715F574A582}"/>
          </ac:spMkLst>
        </pc:spChg>
        <pc:spChg chg="mod">
          <ac:chgData name="GİZEM GÜLPINAR" userId="565a83b7-4207-49a5-b85b-de32e059dfa9" providerId="ADAL" clId="{3A64C15F-44D8-D341-BE5C-5AE8521C82D9}" dt="2024-04-01T13:00:58.266" v="384" actId="403"/>
          <ac:spMkLst>
            <pc:docMk/>
            <pc:sldMk cId="2676113575" sldId="256"/>
            <ac:spMk id="13" creationId="{78B3F6AB-6C87-788A-A57E-A5EE664AF266}"/>
          </ac:spMkLst>
        </pc:spChg>
        <pc:spChg chg="mod">
          <ac:chgData name="GİZEM GÜLPINAR" userId="565a83b7-4207-49a5-b85b-de32e059dfa9" providerId="ADAL" clId="{3A64C15F-44D8-D341-BE5C-5AE8521C82D9}" dt="2024-04-01T13:01:17.807" v="388" actId="255"/>
          <ac:spMkLst>
            <pc:docMk/>
            <pc:sldMk cId="2676113575" sldId="256"/>
            <ac:spMk id="14" creationId="{F93E2545-5D7E-0A67-5C62-028C51D2637D}"/>
          </ac:spMkLst>
        </pc:spChg>
        <pc:spChg chg="add del mod">
          <ac:chgData name="GİZEM GÜLPINAR" userId="565a83b7-4207-49a5-b85b-de32e059dfa9" providerId="ADAL" clId="{3A64C15F-44D8-D341-BE5C-5AE8521C82D9}" dt="2024-04-01T13:07:54.888" v="477" actId="478"/>
          <ac:spMkLst>
            <pc:docMk/>
            <pc:sldMk cId="2676113575" sldId="256"/>
            <ac:spMk id="94" creationId="{13330CDD-5E09-04E9-D49B-0229531A7595}"/>
          </ac:spMkLst>
        </pc:spChg>
        <pc:spChg chg="add mod">
          <ac:chgData name="GİZEM GÜLPINAR" userId="565a83b7-4207-49a5-b85b-de32e059dfa9" providerId="ADAL" clId="{3A64C15F-44D8-D341-BE5C-5AE8521C82D9}" dt="2024-04-01T13:38:55.189" v="642" actId="14100"/>
          <ac:spMkLst>
            <pc:docMk/>
            <pc:sldMk cId="2676113575" sldId="256"/>
            <ac:spMk id="95" creationId="{75F319EF-9E12-893C-AAF9-04CB8AAD46FB}"/>
          </ac:spMkLst>
        </pc:spChg>
        <pc:cxnChg chg="mod">
          <ac:chgData name="GİZEM GÜLPINAR" userId="565a83b7-4207-49a5-b85b-de32e059dfa9" providerId="ADAL" clId="{3A64C15F-44D8-D341-BE5C-5AE8521C82D9}" dt="2024-04-01T13:39:05.112" v="643" actId="14100"/>
          <ac:cxnSpMkLst>
            <pc:docMk/>
            <pc:sldMk cId="2676113575" sldId="256"/>
            <ac:cxnSpMk id="16" creationId="{7C57DF06-FB65-598F-987C-6ABED18E899C}"/>
          </ac:cxnSpMkLst>
        </pc:cxnChg>
        <pc:cxnChg chg="mod">
          <ac:chgData name="GİZEM GÜLPINAR" userId="565a83b7-4207-49a5-b85b-de32e059dfa9" providerId="ADAL" clId="{3A64C15F-44D8-D341-BE5C-5AE8521C82D9}" dt="2024-04-01T13:39:14.237" v="645" actId="14100"/>
          <ac:cxnSpMkLst>
            <pc:docMk/>
            <pc:sldMk cId="2676113575" sldId="256"/>
            <ac:cxnSpMk id="19" creationId="{5DFECBB0-E859-84C9-B50A-8426B5FE9D6E}"/>
          </ac:cxnSpMkLst>
        </pc:cxnChg>
        <pc:cxnChg chg="mod">
          <ac:chgData name="GİZEM GÜLPINAR" userId="565a83b7-4207-49a5-b85b-de32e059dfa9" providerId="ADAL" clId="{3A64C15F-44D8-D341-BE5C-5AE8521C82D9}" dt="2024-04-01T13:39:22.603" v="647" actId="14100"/>
          <ac:cxnSpMkLst>
            <pc:docMk/>
            <pc:sldMk cId="2676113575" sldId="256"/>
            <ac:cxnSpMk id="20" creationId="{FC8D92C6-62A2-B9F5-D83C-96516591EBAA}"/>
          </ac:cxnSpMkLst>
        </pc:cxnChg>
        <pc:cxnChg chg="del mod">
          <ac:chgData name="GİZEM GÜLPINAR" userId="565a83b7-4207-49a5-b85b-de32e059dfa9" providerId="ADAL" clId="{3A64C15F-44D8-D341-BE5C-5AE8521C82D9}" dt="2024-04-01T12:56:23.114" v="329" actId="478"/>
          <ac:cxnSpMkLst>
            <pc:docMk/>
            <pc:sldMk cId="2676113575" sldId="256"/>
            <ac:cxnSpMk id="22" creationId="{93D0F5EB-19F4-C2ED-3C86-84530059D886}"/>
          </ac:cxnSpMkLst>
        </pc:cxnChg>
        <pc:cxnChg chg="mod">
          <ac:chgData name="GİZEM GÜLPINAR" userId="565a83b7-4207-49a5-b85b-de32e059dfa9" providerId="ADAL" clId="{3A64C15F-44D8-D341-BE5C-5AE8521C82D9}" dt="2024-04-01T13:41:58.589" v="702" actId="14100"/>
          <ac:cxnSpMkLst>
            <pc:docMk/>
            <pc:sldMk cId="2676113575" sldId="256"/>
            <ac:cxnSpMk id="28" creationId="{DA52B9BD-8634-F051-00B2-8520F497E52C}"/>
          </ac:cxnSpMkLst>
        </pc:cxnChg>
        <pc:cxnChg chg="mod">
          <ac:chgData name="GİZEM GÜLPINAR" userId="565a83b7-4207-49a5-b85b-de32e059dfa9" providerId="ADAL" clId="{3A64C15F-44D8-D341-BE5C-5AE8521C82D9}" dt="2024-04-01T13:45:04.839" v="737" actId="14100"/>
          <ac:cxnSpMkLst>
            <pc:docMk/>
            <pc:sldMk cId="2676113575" sldId="256"/>
            <ac:cxnSpMk id="29" creationId="{D8162C3A-8CA5-30BB-3E24-21E9A14F9457}"/>
          </ac:cxnSpMkLst>
        </pc:cxnChg>
        <pc:cxnChg chg="add mod">
          <ac:chgData name="GİZEM GÜLPINAR" userId="565a83b7-4207-49a5-b85b-de32e059dfa9" providerId="ADAL" clId="{3A64C15F-44D8-D341-BE5C-5AE8521C82D9}" dt="2024-04-01T13:39:08.588" v="644" actId="14100"/>
          <ac:cxnSpMkLst>
            <pc:docMk/>
            <pc:sldMk cId="2676113575" sldId="256"/>
            <ac:cxnSpMk id="65" creationId="{C2A71A6C-397F-09AD-2C3A-272BE1393CE1}"/>
          </ac:cxnSpMkLst>
        </pc:cxnChg>
        <pc:cxnChg chg="add del mod">
          <ac:chgData name="GİZEM GÜLPINAR" userId="565a83b7-4207-49a5-b85b-de32e059dfa9" providerId="ADAL" clId="{3A64C15F-44D8-D341-BE5C-5AE8521C82D9}" dt="2024-04-01T13:05:47.378" v="447" actId="478"/>
          <ac:cxnSpMkLst>
            <pc:docMk/>
            <pc:sldMk cId="2676113575" sldId="256"/>
            <ac:cxnSpMk id="72" creationId="{697981AE-077D-D250-B975-3898DBA4BC6E}"/>
          </ac:cxnSpMkLst>
        </pc:cxnChg>
      </pc:sldChg>
      <pc:sldMasterChg chg="modSp modSldLayout">
        <pc:chgData name="GİZEM GÜLPINAR" userId="565a83b7-4207-49a5-b85b-de32e059dfa9" providerId="ADAL" clId="{3A64C15F-44D8-D341-BE5C-5AE8521C82D9}" dt="2024-04-01T12:23:54.921" v="36"/>
        <pc:sldMasterMkLst>
          <pc:docMk/>
          <pc:sldMasterMk cId="3987057620" sldId="2147483660"/>
        </pc:sldMasterMkLst>
        <pc:spChg chg="mod">
          <ac:chgData name="GİZEM GÜLPINAR" userId="565a83b7-4207-49a5-b85b-de32e059dfa9" providerId="ADAL" clId="{3A64C15F-44D8-D341-BE5C-5AE8521C82D9}" dt="2024-04-01T12:23:54.921" v="36"/>
          <ac:spMkLst>
            <pc:docMk/>
            <pc:sldMasterMk cId="3987057620" sldId="2147483660"/>
            <ac:spMk id="2" creationId="{00000000-0000-0000-0000-000000000000}"/>
          </ac:spMkLst>
        </pc:spChg>
        <pc:spChg chg="mod">
          <ac:chgData name="GİZEM GÜLPINAR" userId="565a83b7-4207-49a5-b85b-de32e059dfa9" providerId="ADAL" clId="{3A64C15F-44D8-D341-BE5C-5AE8521C82D9}" dt="2024-04-01T12:23:54.921" v="36"/>
          <ac:spMkLst>
            <pc:docMk/>
            <pc:sldMasterMk cId="3987057620" sldId="2147483660"/>
            <ac:spMk id="3" creationId="{00000000-0000-0000-0000-000000000000}"/>
          </ac:spMkLst>
        </pc:spChg>
        <pc:spChg chg="mod">
          <ac:chgData name="GİZEM GÜLPINAR" userId="565a83b7-4207-49a5-b85b-de32e059dfa9" providerId="ADAL" clId="{3A64C15F-44D8-D341-BE5C-5AE8521C82D9}" dt="2024-04-01T12:23:54.921" v="36"/>
          <ac:spMkLst>
            <pc:docMk/>
            <pc:sldMasterMk cId="3987057620" sldId="2147483660"/>
            <ac:spMk id="4" creationId="{00000000-0000-0000-0000-000000000000}"/>
          </ac:spMkLst>
        </pc:spChg>
        <pc:spChg chg="mod">
          <ac:chgData name="GİZEM GÜLPINAR" userId="565a83b7-4207-49a5-b85b-de32e059dfa9" providerId="ADAL" clId="{3A64C15F-44D8-D341-BE5C-5AE8521C82D9}" dt="2024-04-01T12:23:54.921" v="36"/>
          <ac:spMkLst>
            <pc:docMk/>
            <pc:sldMasterMk cId="3987057620" sldId="2147483660"/>
            <ac:spMk id="5" creationId="{00000000-0000-0000-0000-000000000000}"/>
          </ac:spMkLst>
        </pc:spChg>
        <pc:spChg chg="mod">
          <ac:chgData name="GİZEM GÜLPINAR" userId="565a83b7-4207-49a5-b85b-de32e059dfa9" providerId="ADAL" clId="{3A64C15F-44D8-D341-BE5C-5AE8521C82D9}" dt="2024-04-01T12:23:54.921" v="36"/>
          <ac:spMkLst>
            <pc:docMk/>
            <pc:sldMasterMk cId="3987057620" sldId="2147483660"/>
            <ac:spMk id="6" creationId="{00000000-0000-0000-0000-000000000000}"/>
          </ac:spMkLst>
        </pc:spChg>
        <pc:sldLayoutChg chg="modSp">
          <pc:chgData name="GİZEM GÜLPINAR" userId="565a83b7-4207-49a5-b85b-de32e059dfa9" providerId="ADAL" clId="{3A64C15F-44D8-D341-BE5C-5AE8521C82D9}" dt="2024-04-01T12:23:54.921" v="36"/>
          <pc:sldLayoutMkLst>
            <pc:docMk/>
            <pc:sldMasterMk cId="3987057620" sldId="2147483660"/>
            <pc:sldLayoutMk cId="2795508237" sldId="2147483661"/>
          </pc:sldLayoutMkLst>
          <pc:spChg chg="mod">
            <ac:chgData name="GİZEM GÜLPINAR" userId="565a83b7-4207-49a5-b85b-de32e059dfa9" providerId="ADAL" clId="{3A64C15F-44D8-D341-BE5C-5AE8521C82D9}" dt="2024-04-01T12:23:54.921" v="36"/>
            <ac:spMkLst>
              <pc:docMk/>
              <pc:sldMasterMk cId="3987057620" sldId="2147483660"/>
              <pc:sldLayoutMk cId="2795508237" sldId="2147483661"/>
              <ac:spMk id="2" creationId="{00000000-0000-0000-0000-000000000000}"/>
            </ac:spMkLst>
          </pc:spChg>
          <pc:spChg chg="mod">
            <ac:chgData name="GİZEM GÜLPINAR" userId="565a83b7-4207-49a5-b85b-de32e059dfa9" providerId="ADAL" clId="{3A64C15F-44D8-D341-BE5C-5AE8521C82D9}" dt="2024-04-01T12:23:54.921" v="36"/>
            <ac:spMkLst>
              <pc:docMk/>
              <pc:sldMasterMk cId="3987057620" sldId="2147483660"/>
              <pc:sldLayoutMk cId="2795508237" sldId="2147483661"/>
              <ac:spMk id="3" creationId="{00000000-0000-0000-0000-000000000000}"/>
            </ac:spMkLst>
          </pc:spChg>
        </pc:sldLayoutChg>
        <pc:sldLayoutChg chg="modSp">
          <pc:chgData name="GİZEM GÜLPINAR" userId="565a83b7-4207-49a5-b85b-de32e059dfa9" providerId="ADAL" clId="{3A64C15F-44D8-D341-BE5C-5AE8521C82D9}" dt="2024-04-01T12:23:54.921" v="36"/>
          <pc:sldLayoutMkLst>
            <pc:docMk/>
            <pc:sldMasterMk cId="3987057620" sldId="2147483660"/>
            <pc:sldLayoutMk cId="1665325207" sldId="2147483663"/>
          </pc:sldLayoutMkLst>
          <pc:spChg chg="mod">
            <ac:chgData name="GİZEM GÜLPINAR" userId="565a83b7-4207-49a5-b85b-de32e059dfa9" providerId="ADAL" clId="{3A64C15F-44D8-D341-BE5C-5AE8521C82D9}" dt="2024-04-01T12:23:54.921" v="36"/>
            <ac:spMkLst>
              <pc:docMk/>
              <pc:sldMasterMk cId="3987057620" sldId="2147483660"/>
              <pc:sldLayoutMk cId="1665325207" sldId="2147483663"/>
              <ac:spMk id="2" creationId="{00000000-0000-0000-0000-000000000000}"/>
            </ac:spMkLst>
          </pc:spChg>
          <pc:spChg chg="mod">
            <ac:chgData name="GİZEM GÜLPINAR" userId="565a83b7-4207-49a5-b85b-de32e059dfa9" providerId="ADAL" clId="{3A64C15F-44D8-D341-BE5C-5AE8521C82D9}" dt="2024-04-01T12:23:54.921" v="36"/>
            <ac:spMkLst>
              <pc:docMk/>
              <pc:sldMasterMk cId="3987057620" sldId="2147483660"/>
              <pc:sldLayoutMk cId="1665325207" sldId="2147483663"/>
              <ac:spMk id="3" creationId="{00000000-0000-0000-0000-000000000000}"/>
            </ac:spMkLst>
          </pc:spChg>
        </pc:sldLayoutChg>
        <pc:sldLayoutChg chg="modSp">
          <pc:chgData name="GİZEM GÜLPINAR" userId="565a83b7-4207-49a5-b85b-de32e059dfa9" providerId="ADAL" clId="{3A64C15F-44D8-D341-BE5C-5AE8521C82D9}" dt="2024-04-01T12:23:54.921" v="36"/>
          <pc:sldLayoutMkLst>
            <pc:docMk/>
            <pc:sldMasterMk cId="3987057620" sldId="2147483660"/>
            <pc:sldLayoutMk cId="1108636673" sldId="2147483664"/>
          </pc:sldLayoutMkLst>
          <pc:spChg chg="mod">
            <ac:chgData name="GİZEM GÜLPINAR" userId="565a83b7-4207-49a5-b85b-de32e059dfa9" providerId="ADAL" clId="{3A64C15F-44D8-D341-BE5C-5AE8521C82D9}" dt="2024-04-01T12:23:54.921" v="36"/>
            <ac:spMkLst>
              <pc:docMk/>
              <pc:sldMasterMk cId="3987057620" sldId="2147483660"/>
              <pc:sldLayoutMk cId="1108636673" sldId="2147483664"/>
              <ac:spMk id="3" creationId="{00000000-0000-0000-0000-000000000000}"/>
            </ac:spMkLst>
          </pc:spChg>
          <pc:spChg chg="mod">
            <ac:chgData name="GİZEM GÜLPINAR" userId="565a83b7-4207-49a5-b85b-de32e059dfa9" providerId="ADAL" clId="{3A64C15F-44D8-D341-BE5C-5AE8521C82D9}" dt="2024-04-01T12:23:54.921" v="36"/>
            <ac:spMkLst>
              <pc:docMk/>
              <pc:sldMasterMk cId="3987057620" sldId="2147483660"/>
              <pc:sldLayoutMk cId="1108636673" sldId="2147483664"/>
              <ac:spMk id="4" creationId="{00000000-0000-0000-0000-000000000000}"/>
            </ac:spMkLst>
          </pc:spChg>
        </pc:sldLayoutChg>
        <pc:sldLayoutChg chg="modSp">
          <pc:chgData name="GİZEM GÜLPINAR" userId="565a83b7-4207-49a5-b85b-de32e059dfa9" providerId="ADAL" clId="{3A64C15F-44D8-D341-BE5C-5AE8521C82D9}" dt="2024-04-01T12:23:54.921" v="36"/>
          <pc:sldLayoutMkLst>
            <pc:docMk/>
            <pc:sldMasterMk cId="3987057620" sldId="2147483660"/>
            <pc:sldLayoutMk cId="177154583" sldId="2147483665"/>
          </pc:sldLayoutMkLst>
          <pc:spChg chg="mod">
            <ac:chgData name="GİZEM GÜLPINAR" userId="565a83b7-4207-49a5-b85b-de32e059dfa9" providerId="ADAL" clId="{3A64C15F-44D8-D341-BE5C-5AE8521C82D9}" dt="2024-04-01T12:23:54.921" v="36"/>
            <ac:spMkLst>
              <pc:docMk/>
              <pc:sldMasterMk cId="3987057620" sldId="2147483660"/>
              <pc:sldLayoutMk cId="177154583" sldId="2147483665"/>
              <ac:spMk id="2" creationId="{00000000-0000-0000-0000-000000000000}"/>
            </ac:spMkLst>
          </pc:spChg>
          <pc:spChg chg="mod">
            <ac:chgData name="GİZEM GÜLPINAR" userId="565a83b7-4207-49a5-b85b-de32e059dfa9" providerId="ADAL" clId="{3A64C15F-44D8-D341-BE5C-5AE8521C82D9}" dt="2024-04-01T12:23:54.921" v="36"/>
            <ac:spMkLst>
              <pc:docMk/>
              <pc:sldMasterMk cId="3987057620" sldId="2147483660"/>
              <pc:sldLayoutMk cId="177154583" sldId="2147483665"/>
              <ac:spMk id="3" creationId="{00000000-0000-0000-0000-000000000000}"/>
            </ac:spMkLst>
          </pc:spChg>
          <pc:spChg chg="mod">
            <ac:chgData name="GİZEM GÜLPINAR" userId="565a83b7-4207-49a5-b85b-de32e059dfa9" providerId="ADAL" clId="{3A64C15F-44D8-D341-BE5C-5AE8521C82D9}" dt="2024-04-01T12:23:54.921" v="36"/>
            <ac:spMkLst>
              <pc:docMk/>
              <pc:sldMasterMk cId="3987057620" sldId="2147483660"/>
              <pc:sldLayoutMk cId="177154583" sldId="2147483665"/>
              <ac:spMk id="4" creationId="{00000000-0000-0000-0000-000000000000}"/>
            </ac:spMkLst>
          </pc:spChg>
          <pc:spChg chg="mod">
            <ac:chgData name="GİZEM GÜLPINAR" userId="565a83b7-4207-49a5-b85b-de32e059dfa9" providerId="ADAL" clId="{3A64C15F-44D8-D341-BE5C-5AE8521C82D9}" dt="2024-04-01T12:23:54.921" v="36"/>
            <ac:spMkLst>
              <pc:docMk/>
              <pc:sldMasterMk cId="3987057620" sldId="2147483660"/>
              <pc:sldLayoutMk cId="177154583" sldId="2147483665"/>
              <ac:spMk id="5" creationId="{00000000-0000-0000-0000-000000000000}"/>
            </ac:spMkLst>
          </pc:spChg>
          <pc:spChg chg="mod">
            <ac:chgData name="GİZEM GÜLPINAR" userId="565a83b7-4207-49a5-b85b-de32e059dfa9" providerId="ADAL" clId="{3A64C15F-44D8-D341-BE5C-5AE8521C82D9}" dt="2024-04-01T12:23:54.921" v="36"/>
            <ac:spMkLst>
              <pc:docMk/>
              <pc:sldMasterMk cId="3987057620" sldId="2147483660"/>
              <pc:sldLayoutMk cId="177154583" sldId="2147483665"/>
              <ac:spMk id="6" creationId="{00000000-0000-0000-0000-000000000000}"/>
            </ac:spMkLst>
          </pc:spChg>
        </pc:sldLayoutChg>
        <pc:sldLayoutChg chg="modSp">
          <pc:chgData name="GİZEM GÜLPINAR" userId="565a83b7-4207-49a5-b85b-de32e059dfa9" providerId="ADAL" clId="{3A64C15F-44D8-D341-BE5C-5AE8521C82D9}" dt="2024-04-01T12:23:54.921" v="36"/>
          <pc:sldLayoutMkLst>
            <pc:docMk/>
            <pc:sldMasterMk cId="3987057620" sldId="2147483660"/>
            <pc:sldLayoutMk cId="2821269295" sldId="2147483668"/>
          </pc:sldLayoutMkLst>
          <pc:spChg chg="mod">
            <ac:chgData name="GİZEM GÜLPINAR" userId="565a83b7-4207-49a5-b85b-de32e059dfa9" providerId="ADAL" clId="{3A64C15F-44D8-D341-BE5C-5AE8521C82D9}" dt="2024-04-01T12:23:54.921" v="36"/>
            <ac:spMkLst>
              <pc:docMk/>
              <pc:sldMasterMk cId="3987057620" sldId="2147483660"/>
              <pc:sldLayoutMk cId="2821269295" sldId="2147483668"/>
              <ac:spMk id="2" creationId="{00000000-0000-0000-0000-000000000000}"/>
            </ac:spMkLst>
          </pc:spChg>
          <pc:spChg chg="mod">
            <ac:chgData name="GİZEM GÜLPINAR" userId="565a83b7-4207-49a5-b85b-de32e059dfa9" providerId="ADAL" clId="{3A64C15F-44D8-D341-BE5C-5AE8521C82D9}" dt="2024-04-01T12:23:54.921" v="36"/>
            <ac:spMkLst>
              <pc:docMk/>
              <pc:sldMasterMk cId="3987057620" sldId="2147483660"/>
              <pc:sldLayoutMk cId="2821269295" sldId="2147483668"/>
              <ac:spMk id="3" creationId="{00000000-0000-0000-0000-000000000000}"/>
            </ac:spMkLst>
          </pc:spChg>
          <pc:spChg chg="mod">
            <ac:chgData name="GİZEM GÜLPINAR" userId="565a83b7-4207-49a5-b85b-de32e059dfa9" providerId="ADAL" clId="{3A64C15F-44D8-D341-BE5C-5AE8521C82D9}" dt="2024-04-01T12:23:54.921" v="36"/>
            <ac:spMkLst>
              <pc:docMk/>
              <pc:sldMasterMk cId="3987057620" sldId="2147483660"/>
              <pc:sldLayoutMk cId="2821269295" sldId="2147483668"/>
              <ac:spMk id="4" creationId="{00000000-0000-0000-0000-000000000000}"/>
            </ac:spMkLst>
          </pc:spChg>
        </pc:sldLayoutChg>
        <pc:sldLayoutChg chg="modSp">
          <pc:chgData name="GİZEM GÜLPINAR" userId="565a83b7-4207-49a5-b85b-de32e059dfa9" providerId="ADAL" clId="{3A64C15F-44D8-D341-BE5C-5AE8521C82D9}" dt="2024-04-01T12:23:54.921" v="36"/>
          <pc:sldLayoutMkLst>
            <pc:docMk/>
            <pc:sldMasterMk cId="3987057620" sldId="2147483660"/>
            <pc:sldLayoutMk cId="4129590856" sldId="2147483669"/>
          </pc:sldLayoutMkLst>
          <pc:spChg chg="mod">
            <ac:chgData name="GİZEM GÜLPINAR" userId="565a83b7-4207-49a5-b85b-de32e059dfa9" providerId="ADAL" clId="{3A64C15F-44D8-D341-BE5C-5AE8521C82D9}" dt="2024-04-01T12:23:54.921" v="36"/>
            <ac:spMkLst>
              <pc:docMk/>
              <pc:sldMasterMk cId="3987057620" sldId="2147483660"/>
              <pc:sldLayoutMk cId="4129590856" sldId="2147483669"/>
              <ac:spMk id="2" creationId="{00000000-0000-0000-0000-000000000000}"/>
            </ac:spMkLst>
          </pc:spChg>
          <pc:spChg chg="mod">
            <ac:chgData name="GİZEM GÜLPINAR" userId="565a83b7-4207-49a5-b85b-de32e059dfa9" providerId="ADAL" clId="{3A64C15F-44D8-D341-BE5C-5AE8521C82D9}" dt="2024-04-01T12:23:54.921" v="36"/>
            <ac:spMkLst>
              <pc:docMk/>
              <pc:sldMasterMk cId="3987057620" sldId="2147483660"/>
              <pc:sldLayoutMk cId="4129590856" sldId="2147483669"/>
              <ac:spMk id="3" creationId="{00000000-0000-0000-0000-000000000000}"/>
            </ac:spMkLst>
          </pc:spChg>
          <pc:spChg chg="mod">
            <ac:chgData name="GİZEM GÜLPINAR" userId="565a83b7-4207-49a5-b85b-de32e059dfa9" providerId="ADAL" clId="{3A64C15F-44D8-D341-BE5C-5AE8521C82D9}" dt="2024-04-01T12:23:54.921" v="36"/>
            <ac:spMkLst>
              <pc:docMk/>
              <pc:sldMasterMk cId="3987057620" sldId="2147483660"/>
              <pc:sldLayoutMk cId="4129590856" sldId="2147483669"/>
              <ac:spMk id="4" creationId="{00000000-0000-0000-0000-000000000000}"/>
            </ac:spMkLst>
          </pc:spChg>
        </pc:sldLayoutChg>
        <pc:sldLayoutChg chg="modSp">
          <pc:chgData name="GİZEM GÜLPINAR" userId="565a83b7-4207-49a5-b85b-de32e059dfa9" providerId="ADAL" clId="{3A64C15F-44D8-D341-BE5C-5AE8521C82D9}" dt="2024-04-01T12:23:54.921" v="36"/>
          <pc:sldLayoutMkLst>
            <pc:docMk/>
            <pc:sldMasterMk cId="3987057620" sldId="2147483660"/>
            <pc:sldLayoutMk cId="705441969" sldId="2147483671"/>
          </pc:sldLayoutMkLst>
          <pc:spChg chg="mod">
            <ac:chgData name="GİZEM GÜLPINAR" userId="565a83b7-4207-49a5-b85b-de32e059dfa9" providerId="ADAL" clId="{3A64C15F-44D8-D341-BE5C-5AE8521C82D9}" dt="2024-04-01T12:23:54.921" v="36"/>
            <ac:spMkLst>
              <pc:docMk/>
              <pc:sldMasterMk cId="3987057620" sldId="2147483660"/>
              <pc:sldLayoutMk cId="705441969" sldId="2147483671"/>
              <ac:spMk id="2" creationId="{00000000-0000-0000-0000-000000000000}"/>
            </ac:spMkLst>
          </pc:spChg>
          <pc:spChg chg="mod">
            <ac:chgData name="GİZEM GÜLPINAR" userId="565a83b7-4207-49a5-b85b-de32e059dfa9" providerId="ADAL" clId="{3A64C15F-44D8-D341-BE5C-5AE8521C82D9}" dt="2024-04-01T12:23:54.921" v="36"/>
            <ac:spMkLst>
              <pc:docMk/>
              <pc:sldMasterMk cId="3987057620" sldId="2147483660"/>
              <pc:sldLayoutMk cId="705441969" sldId="2147483671"/>
              <ac:spMk id="3" creationId="{00000000-0000-0000-0000-000000000000}"/>
            </ac:spMkLst>
          </pc:spChg>
        </pc:sldLayoutChg>
      </pc:sldMaster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Üst Bilgi Yer Tutucusu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tr-TR"/>
          </a:p>
        </p:txBody>
      </p:sp>
      <p:sp>
        <p:nvSpPr>
          <p:cNvPr id="3" name="Veri Yer Tutucusu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58FD4D3-BA5B-7F4F-AB4F-FE7FFF4846D7}" type="datetimeFigureOut">
              <a:rPr lang="tr-TR" smtClean="0"/>
              <a:t>1.04.2024</a:t>
            </a:fld>
            <a:endParaRPr lang="tr-TR"/>
          </a:p>
        </p:txBody>
      </p:sp>
      <p:sp>
        <p:nvSpPr>
          <p:cNvPr id="4" name="Slayt Resmi Yer Tutucusu 3"/>
          <p:cNvSpPr>
            <a:spLocks noGrp="1" noRot="1" noChangeAspect="1"/>
          </p:cNvSpPr>
          <p:nvPr>
            <p:ph type="sldImg" idx="2"/>
          </p:nvPr>
        </p:nvSpPr>
        <p:spPr>
          <a:xfrm>
            <a:off x="1830388" y="1143000"/>
            <a:ext cx="3197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tr-TR"/>
          </a:p>
        </p:txBody>
      </p:sp>
      <p:sp>
        <p:nvSpPr>
          <p:cNvPr id="5" name="Not Yer Tutucusu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6" name="Alt Bilgi Yer Tutucusu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tr-TR"/>
          </a:p>
        </p:txBody>
      </p:sp>
      <p:sp>
        <p:nvSpPr>
          <p:cNvPr id="7" name="Slayt Numarası Yer Tutucusu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55F5928-D216-FC46-8FDF-941C634FDF5D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3184800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32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162" algn="l" defTabSz="91432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323" algn="l" defTabSz="91432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485" algn="l" defTabSz="91432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646" algn="l" defTabSz="91432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5808" algn="l" defTabSz="91432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2969" algn="l" defTabSz="91432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131" algn="l" defTabSz="91432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293" algn="l" defTabSz="91432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ayt Resmi Yer Tutucus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 Yer Tutucusu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tr-TR" dirty="0"/>
          </a:p>
        </p:txBody>
      </p:sp>
      <p:sp>
        <p:nvSpPr>
          <p:cNvPr id="4" name="Slayt Numarası Yer Tutucusu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55F5928-D216-FC46-8FDF-941C634FDF5D}" type="slidenum">
              <a:rPr lang="tr-TR" smtClean="0"/>
              <a:t>1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31543615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Başlık Slayd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46786" y="1994274"/>
            <a:ext cx="10730230" cy="4242411"/>
          </a:xfrm>
        </p:spPr>
        <p:txBody>
          <a:bodyPr anchor="b"/>
          <a:lstStyle>
            <a:lvl1pPr algn="ctr">
              <a:defRPr sz="8284"/>
            </a:lvl1pPr>
          </a:lstStyle>
          <a:p>
            <a:r>
              <a:rPr lang="tr-TR"/>
              <a:t>Asıl başlık stilini düzenlemek için tıklayı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77976" y="6400288"/>
            <a:ext cx="9467850" cy="2942044"/>
          </a:xfrm>
        </p:spPr>
        <p:txBody>
          <a:bodyPr/>
          <a:lstStyle>
            <a:lvl1pPr marL="0" indent="0" algn="ctr">
              <a:buNone/>
              <a:defRPr sz="3313"/>
            </a:lvl1pPr>
            <a:lvl2pPr marL="631203" indent="0" algn="ctr">
              <a:buNone/>
              <a:defRPr sz="2761"/>
            </a:lvl2pPr>
            <a:lvl3pPr marL="1262407" indent="0" algn="ctr">
              <a:buNone/>
              <a:defRPr sz="2485"/>
            </a:lvl3pPr>
            <a:lvl4pPr marL="1893610" indent="0" algn="ctr">
              <a:buNone/>
              <a:defRPr sz="2209"/>
            </a:lvl4pPr>
            <a:lvl5pPr marL="2524813" indent="0" algn="ctr">
              <a:buNone/>
              <a:defRPr sz="2209"/>
            </a:lvl5pPr>
            <a:lvl6pPr marL="3156018" indent="0" algn="ctr">
              <a:buNone/>
              <a:defRPr sz="2209"/>
            </a:lvl6pPr>
            <a:lvl7pPr marL="3787221" indent="0" algn="ctr">
              <a:buNone/>
              <a:defRPr sz="2209"/>
            </a:lvl7pPr>
            <a:lvl8pPr marL="4418424" indent="0" algn="ctr">
              <a:buNone/>
              <a:defRPr sz="2209"/>
            </a:lvl8pPr>
            <a:lvl9pPr marL="5049628" indent="0" algn="ctr">
              <a:buNone/>
              <a:defRPr sz="2209"/>
            </a:lvl9pPr>
          </a:lstStyle>
          <a:p>
            <a:r>
              <a:rPr lang="tr-TR"/>
              <a:t>Asıl alt başlık stilini düzenlemek için tıklayı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8AEFF-5C9A-0B41-B117-B142157858A1}" type="datetimeFigureOut">
              <a:rPr lang="tr-TR" smtClean="0"/>
              <a:t>1.04.2024</a:t>
            </a:fld>
            <a:endParaRPr lang="tr-T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B73FA-A481-B24C-8628-A2AAF2711293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27955082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Başlık ve Dikey Meti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8AEFF-5C9A-0B41-B117-B142157858A1}" type="datetimeFigureOut">
              <a:rPr lang="tr-TR" smtClean="0"/>
              <a:t>1.04.2024</a:t>
            </a:fld>
            <a:endParaRPr lang="tr-T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B73FA-A481-B24C-8628-A2AAF2711293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2265160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Dikey Başlık ve Meti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033909" y="648773"/>
            <a:ext cx="2722007" cy="10326775"/>
          </a:xfrm>
        </p:spPr>
        <p:txBody>
          <a:bodyPr vert="eaVert"/>
          <a:lstStyle/>
          <a:p>
            <a:r>
              <a:rPr lang="tr-TR"/>
              <a:t>Asıl başlık stilini düzenlemek için tıklayı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67888" y="648773"/>
            <a:ext cx="8008223" cy="10326775"/>
          </a:xfrm>
        </p:spPr>
        <p:txBody>
          <a:bodyPr vert="eaVert"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8AEFF-5C9A-0B41-B117-B142157858A1}" type="datetimeFigureOut">
              <a:rPr lang="tr-TR" smtClean="0"/>
              <a:t>1.04.2024</a:t>
            </a:fld>
            <a:endParaRPr lang="tr-T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B73FA-A481-B24C-8628-A2AAF2711293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7054419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aşlık ve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8AEFF-5C9A-0B41-B117-B142157858A1}" type="datetimeFigureOut">
              <a:rPr lang="tr-TR" smtClean="0"/>
              <a:t>1.04.2024</a:t>
            </a:fld>
            <a:endParaRPr lang="tr-T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B73FA-A481-B24C-8628-A2AAF2711293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8880155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Bölüm Üst Bilgis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1313" y="3037955"/>
            <a:ext cx="10888028" cy="5068891"/>
          </a:xfrm>
        </p:spPr>
        <p:txBody>
          <a:bodyPr anchor="b"/>
          <a:lstStyle>
            <a:lvl1pPr>
              <a:defRPr sz="8284"/>
            </a:lvl1pPr>
          </a:lstStyle>
          <a:p>
            <a:r>
              <a:rPr lang="tr-TR"/>
              <a:t>Asıl başlık stilini düzenlemek için tıklayı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1313" y="8154799"/>
            <a:ext cx="10888028" cy="2665610"/>
          </a:xfrm>
        </p:spPr>
        <p:txBody>
          <a:bodyPr/>
          <a:lstStyle>
            <a:lvl1pPr marL="0" indent="0">
              <a:buNone/>
              <a:defRPr sz="3313">
                <a:solidFill>
                  <a:schemeClr val="tx1"/>
                </a:solidFill>
              </a:defRPr>
            </a:lvl1pPr>
            <a:lvl2pPr marL="631203" indent="0">
              <a:buNone/>
              <a:defRPr sz="2761">
                <a:solidFill>
                  <a:schemeClr val="tx1">
                    <a:tint val="75000"/>
                  </a:schemeClr>
                </a:solidFill>
              </a:defRPr>
            </a:lvl2pPr>
            <a:lvl3pPr marL="1262407" indent="0">
              <a:buNone/>
              <a:defRPr sz="2485">
                <a:solidFill>
                  <a:schemeClr val="tx1">
                    <a:tint val="75000"/>
                  </a:schemeClr>
                </a:solidFill>
              </a:defRPr>
            </a:lvl3pPr>
            <a:lvl4pPr marL="1893610" indent="0">
              <a:buNone/>
              <a:defRPr sz="2209">
                <a:solidFill>
                  <a:schemeClr val="tx1">
                    <a:tint val="75000"/>
                  </a:schemeClr>
                </a:solidFill>
              </a:defRPr>
            </a:lvl4pPr>
            <a:lvl5pPr marL="2524813" indent="0">
              <a:buNone/>
              <a:defRPr sz="2209">
                <a:solidFill>
                  <a:schemeClr val="tx1">
                    <a:tint val="75000"/>
                  </a:schemeClr>
                </a:solidFill>
              </a:defRPr>
            </a:lvl5pPr>
            <a:lvl6pPr marL="3156018" indent="0">
              <a:buNone/>
              <a:defRPr sz="2209">
                <a:solidFill>
                  <a:schemeClr val="tx1">
                    <a:tint val="75000"/>
                  </a:schemeClr>
                </a:solidFill>
              </a:defRPr>
            </a:lvl6pPr>
            <a:lvl7pPr marL="3787221" indent="0">
              <a:buNone/>
              <a:defRPr sz="2209">
                <a:solidFill>
                  <a:schemeClr val="tx1">
                    <a:tint val="75000"/>
                  </a:schemeClr>
                </a:solidFill>
              </a:defRPr>
            </a:lvl7pPr>
            <a:lvl8pPr marL="4418424" indent="0">
              <a:buNone/>
              <a:defRPr sz="2209">
                <a:solidFill>
                  <a:schemeClr val="tx1">
                    <a:tint val="75000"/>
                  </a:schemeClr>
                </a:solidFill>
              </a:defRPr>
            </a:lvl8pPr>
            <a:lvl9pPr marL="5049628" indent="0">
              <a:buNone/>
              <a:defRPr sz="220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8AEFF-5C9A-0B41-B117-B142157858A1}" type="datetimeFigureOut">
              <a:rPr lang="tr-TR" smtClean="0"/>
              <a:t>1.04.2024</a:t>
            </a:fld>
            <a:endParaRPr lang="tr-T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B73FA-A481-B24C-8628-A2AAF2711293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6653252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İki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67887" y="3243866"/>
            <a:ext cx="5365115" cy="7731683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390799" y="3243866"/>
            <a:ext cx="5365115" cy="7731683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8AEFF-5C9A-0B41-B117-B142157858A1}" type="datetimeFigureOut">
              <a:rPr lang="tr-TR" smtClean="0"/>
              <a:t>1.04.2024</a:t>
            </a:fld>
            <a:endParaRPr lang="tr-T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B73FA-A481-B24C-8628-A2AAF2711293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1086366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Karşılaştırm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9531" y="648776"/>
            <a:ext cx="10888028" cy="2355329"/>
          </a:xfrm>
        </p:spPr>
        <p:txBody>
          <a:bodyPr/>
          <a:lstStyle/>
          <a:p>
            <a:r>
              <a:rPr lang="tr-TR"/>
              <a:t>Asıl başlık stilini düzenlemek için tıklayı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9533" y="2987177"/>
            <a:ext cx="5340458" cy="1463971"/>
          </a:xfrm>
        </p:spPr>
        <p:txBody>
          <a:bodyPr anchor="b"/>
          <a:lstStyle>
            <a:lvl1pPr marL="0" indent="0">
              <a:buNone/>
              <a:defRPr sz="3313" b="1"/>
            </a:lvl1pPr>
            <a:lvl2pPr marL="631203" indent="0">
              <a:buNone/>
              <a:defRPr sz="2761" b="1"/>
            </a:lvl2pPr>
            <a:lvl3pPr marL="1262407" indent="0">
              <a:buNone/>
              <a:defRPr sz="2485" b="1"/>
            </a:lvl3pPr>
            <a:lvl4pPr marL="1893610" indent="0">
              <a:buNone/>
              <a:defRPr sz="2209" b="1"/>
            </a:lvl4pPr>
            <a:lvl5pPr marL="2524813" indent="0">
              <a:buNone/>
              <a:defRPr sz="2209" b="1"/>
            </a:lvl5pPr>
            <a:lvl6pPr marL="3156018" indent="0">
              <a:buNone/>
              <a:defRPr sz="2209" b="1"/>
            </a:lvl6pPr>
            <a:lvl7pPr marL="3787221" indent="0">
              <a:buNone/>
              <a:defRPr sz="2209" b="1"/>
            </a:lvl7pPr>
            <a:lvl8pPr marL="4418424" indent="0">
              <a:buNone/>
              <a:defRPr sz="2209" b="1"/>
            </a:lvl8pPr>
            <a:lvl9pPr marL="5049628" indent="0">
              <a:buNone/>
              <a:defRPr sz="2209" b="1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69533" y="4451148"/>
            <a:ext cx="5340458" cy="6546967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390801" y="2987177"/>
            <a:ext cx="5366759" cy="1463971"/>
          </a:xfrm>
        </p:spPr>
        <p:txBody>
          <a:bodyPr anchor="b"/>
          <a:lstStyle>
            <a:lvl1pPr marL="0" indent="0">
              <a:buNone/>
              <a:defRPr sz="3313" b="1"/>
            </a:lvl1pPr>
            <a:lvl2pPr marL="631203" indent="0">
              <a:buNone/>
              <a:defRPr sz="2761" b="1"/>
            </a:lvl2pPr>
            <a:lvl3pPr marL="1262407" indent="0">
              <a:buNone/>
              <a:defRPr sz="2485" b="1"/>
            </a:lvl3pPr>
            <a:lvl4pPr marL="1893610" indent="0">
              <a:buNone/>
              <a:defRPr sz="2209" b="1"/>
            </a:lvl4pPr>
            <a:lvl5pPr marL="2524813" indent="0">
              <a:buNone/>
              <a:defRPr sz="2209" b="1"/>
            </a:lvl5pPr>
            <a:lvl6pPr marL="3156018" indent="0">
              <a:buNone/>
              <a:defRPr sz="2209" b="1"/>
            </a:lvl6pPr>
            <a:lvl7pPr marL="3787221" indent="0">
              <a:buNone/>
              <a:defRPr sz="2209" b="1"/>
            </a:lvl7pPr>
            <a:lvl8pPr marL="4418424" indent="0">
              <a:buNone/>
              <a:defRPr sz="2209" b="1"/>
            </a:lvl8pPr>
            <a:lvl9pPr marL="5049628" indent="0">
              <a:buNone/>
              <a:defRPr sz="2209" b="1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390801" y="4451148"/>
            <a:ext cx="5366759" cy="6546967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8AEFF-5C9A-0B41-B117-B142157858A1}" type="datetimeFigureOut">
              <a:rPr lang="tr-TR" smtClean="0"/>
              <a:t>1.04.2024</a:t>
            </a:fld>
            <a:endParaRPr lang="tr-T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B73FA-A481-B24C-8628-A2AAF2711293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771545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Yalnızca Başlı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8AEFF-5C9A-0B41-B117-B142157858A1}" type="datetimeFigureOut">
              <a:rPr lang="tr-TR" smtClean="0"/>
              <a:t>1.04.2024</a:t>
            </a:fld>
            <a:endParaRPr lang="tr-T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B73FA-A481-B24C-8628-A2AAF2711293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4925300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o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8AEFF-5C9A-0B41-B117-B142157858A1}" type="datetimeFigureOut">
              <a:rPr lang="tr-TR" smtClean="0"/>
              <a:t>1.04.2024</a:t>
            </a:fld>
            <a:endParaRPr lang="tr-T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B73FA-A481-B24C-8628-A2AAF2711293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34706979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Başlıklı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9531" y="812377"/>
            <a:ext cx="4071504" cy="2843318"/>
          </a:xfrm>
        </p:spPr>
        <p:txBody>
          <a:bodyPr anchor="b"/>
          <a:lstStyle>
            <a:lvl1pPr>
              <a:defRPr sz="4418"/>
            </a:lvl1pPr>
          </a:lstStyle>
          <a:p>
            <a:r>
              <a:rPr lang="tr-TR"/>
              <a:t>Asıl başlık stilini düzenlemek için tıklayı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66760" y="1754510"/>
            <a:ext cx="6390799" cy="8659710"/>
          </a:xfrm>
        </p:spPr>
        <p:txBody>
          <a:bodyPr/>
          <a:lstStyle>
            <a:lvl1pPr>
              <a:defRPr sz="4418"/>
            </a:lvl1pPr>
            <a:lvl2pPr>
              <a:defRPr sz="3866"/>
            </a:lvl2pPr>
            <a:lvl3pPr>
              <a:defRPr sz="3313"/>
            </a:lvl3pPr>
            <a:lvl4pPr>
              <a:defRPr sz="2761"/>
            </a:lvl4pPr>
            <a:lvl5pPr>
              <a:defRPr sz="2761"/>
            </a:lvl5pPr>
            <a:lvl6pPr>
              <a:defRPr sz="2761"/>
            </a:lvl6pPr>
            <a:lvl7pPr>
              <a:defRPr sz="2761"/>
            </a:lvl7pPr>
            <a:lvl8pPr>
              <a:defRPr sz="2761"/>
            </a:lvl8pPr>
            <a:lvl9pPr>
              <a:defRPr sz="2761"/>
            </a:lvl9pPr>
          </a:lstStyle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9531" y="3655696"/>
            <a:ext cx="4071504" cy="6772627"/>
          </a:xfrm>
        </p:spPr>
        <p:txBody>
          <a:bodyPr/>
          <a:lstStyle>
            <a:lvl1pPr marL="0" indent="0">
              <a:buNone/>
              <a:defRPr sz="2209"/>
            </a:lvl1pPr>
            <a:lvl2pPr marL="631203" indent="0">
              <a:buNone/>
              <a:defRPr sz="1932"/>
            </a:lvl2pPr>
            <a:lvl3pPr marL="1262407" indent="0">
              <a:buNone/>
              <a:defRPr sz="1657"/>
            </a:lvl3pPr>
            <a:lvl4pPr marL="1893610" indent="0">
              <a:buNone/>
              <a:defRPr sz="1381"/>
            </a:lvl4pPr>
            <a:lvl5pPr marL="2524813" indent="0">
              <a:buNone/>
              <a:defRPr sz="1381"/>
            </a:lvl5pPr>
            <a:lvl6pPr marL="3156018" indent="0">
              <a:buNone/>
              <a:defRPr sz="1381"/>
            </a:lvl6pPr>
            <a:lvl7pPr marL="3787221" indent="0">
              <a:buNone/>
              <a:defRPr sz="1381"/>
            </a:lvl7pPr>
            <a:lvl8pPr marL="4418424" indent="0">
              <a:buNone/>
              <a:defRPr sz="1381"/>
            </a:lvl8pPr>
            <a:lvl9pPr marL="5049628" indent="0">
              <a:buNone/>
              <a:defRPr sz="1381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8AEFF-5C9A-0B41-B117-B142157858A1}" type="datetimeFigureOut">
              <a:rPr lang="tr-TR" smtClean="0"/>
              <a:t>1.04.2024</a:t>
            </a:fld>
            <a:endParaRPr lang="tr-T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B73FA-A481-B24C-8628-A2AAF2711293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28212692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aşlıklı Resi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9531" y="812377"/>
            <a:ext cx="4071504" cy="2843318"/>
          </a:xfrm>
        </p:spPr>
        <p:txBody>
          <a:bodyPr anchor="b"/>
          <a:lstStyle>
            <a:lvl1pPr>
              <a:defRPr sz="4418"/>
            </a:lvl1pPr>
          </a:lstStyle>
          <a:p>
            <a:r>
              <a:rPr lang="tr-TR"/>
              <a:t>Asıl başlık stilini düzenlemek için tıklayı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366760" y="1754510"/>
            <a:ext cx="6390799" cy="8659710"/>
          </a:xfrm>
        </p:spPr>
        <p:txBody>
          <a:bodyPr anchor="t"/>
          <a:lstStyle>
            <a:lvl1pPr marL="0" indent="0">
              <a:buNone/>
              <a:defRPr sz="4418"/>
            </a:lvl1pPr>
            <a:lvl2pPr marL="631203" indent="0">
              <a:buNone/>
              <a:defRPr sz="3866"/>
            </a:lvl2pPr>
            <a:lvl3pPr marL="1262407" indent="0">
              <a:buNone/>
              <a:defRPr sz="3313"/>
            </a:lvl3pPr>
            <a:lvl4pPr marL="1893610" indent="0">
              <a:buNone/>
              <a:defRPr sz="2761"/>
            </a:lvl4pPr>
            <a:lvl5pPr marL="2524813" indent="0">
              <a:buNone/>
              <a:defRPr sz="2761"/>
            </a:lvl5pPr>
            <a:lvl6pPr marL="3156018" indent="0">
              <a:buNone/>
              <a:defRPr sz="2761"/>
            </a:lvl6pPr>
            <a:lvl7pPr marL="3787221" indent="0">
              <a:buNone/>
              <a:defRPr sz="2761"/>
            </a:lvl7pPr>
            <a:lvl8pPr marL="4418424" indent="0">
              <a:buNone/>
              <a:defRPr sz="2761"/>
            </a:lvl8pPr>
            <a:lvl9pPr marL="5049628" indent="0">
              <a:buNone/>
              <a:defRPr sz="2761"/>
            </a:lvl9pPr>
          </a:lstStyle>
          <a:p>
            <a:r>
              <a:rPr lang="tr-TR"/>
              <a:t>Resim eklemek için simgeye tıklayı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9531" y="3655696"/>
            <a:ext cx="4071504" cy="6772627"/>
          </a:xfrm>
        </p:spPr>
        <p:txBody>
          <a:bodyPr/>
          <a:lstStyle>
            <a:lvl1pPr marL="0" indent="0">
              <a:buNone/>
              <a:defRPr sz="2209"/>
            </a:lvl1pPr>
            <a:lvl2pPr marL="631203" indent="0">
              <a:buNone/>
              <a:defRPr sz="1932"/>
            </a:lvl2pPr>
            <a:lvl3pPr marL="1262407" indent="0">
              <a:buNone/>
              <a:defRPr sz="1657"/>
            </a:lvl3pPr>
            <a:lvl4pPr marL="1893610" indent="0">
              <a:buNone/>
              <a:defRPr sz="1381"/>
            </a:lvl4pPr>
            <a:lvl5pPr marL="2524813" indent="0">
              <a:buNone/>
              <a:defRPr sz="1381"/>
            </a:lvl5pPr>
            <a:lvl6pPr marL="3156018" indent="0">
              <a:buNone/>
              <a:defRPr sz="1381"/>
            </a:lvl6pPr>
            <a:lvl7pPr marL="3787221" indent="0">
              <a:buNone/>
              <a:defRPr sz="1381"/>
            </a:lvl7pPr>
            <a:lvl8pPr marL="4418424" indent="0">
              <a:buNone/>
              <a:defRPr sz="1381"/>
            </a:lvl8pPr>
            <a:lvl9pPr marL="5049628" indent="0">
              <a:buNone/>
              <a:defRPr sz="1381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8AEFF-5C9A-0B41-B117-B142157858A1}" type="datetimeFigureOut">
              <a:rPr lang="tr-TR" smtClean="0"/>
              <a:t>1.04.2024</a:t>
            </a:fld>
            <a:endParaRPr lang="tr-T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B73FA-A481-B24C-8628-A2AAF2711293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41295908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67887" y="648776"/>
            <a:ext cx="10888028" cy="235532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tr-TR"/>
              <a:t>Asıl başlık stilini düzenlemek için tıklayı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7887" y="3243866"/>
            <a:ext cx="10888028" cy="77316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67887" y="11294295"/>
            <a:ext cx="2840355" cy="6487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5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E8AEFF-5C9A-0B41-B117-B142157858A1}" type="datetimeFigureOut">
              <a:rPr lang="tr-TR" smtClean="0"/>
              <a:t>1.04.2024</a:t>
            </a:fld>
            <a:endParaRPr lang="tr-T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81634" y="11294295"/>
            <a:ext cx="4260533" cy="6487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5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tr-T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915560" y="11294295"/>
            <a:ext cx="2840355" cy="6487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5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BB73FA-A481-B24C-8628-A2AAF2711293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3987057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62407" rtl="0" eaLnBrk="1" latinLnBrk="0" hangingPunct="1">
        <a:lnSpc>
          <a:spcPct val="90000"/>
        </a:lnSpc>
        <a:spcBef>
          <a:spcPct val="0"/>
        </a:spcBef>
        <a:buNone/>
        <a:defRPr sz="60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15602" indent="-315602" algn="l" defTabSz="1262407" rtl="0" eaLnBrk="1" latinLnBrk="0" hangingPunct="1">
        <a:lnSpc>
          <a:spcPct val="90000"/>
        </a:lnSpc>
        <a:spcBef>
          <a:spcPts val="1381"/>
        </a:spcBef>
        <a:buFont typeface="Arial" panose="020B0604020202020204" pitchFamily="34" charset="0"/>
        <a:buChar char="•"/>
        <a:defRPr sz="3866" kern="1200">
          <a:solidFill>
            <a:schemeClr val="tx1"/>
          </a:solidFill>
          <a:latin typeface="+mn-lt"/>
          <a:ea typeface="+mn-ea"/>
          <a:cs typeface="+mn-cs"/>
        </a:defRPr>
      </a:lvl1pPr>
      <a:lvl2pPr marL="946805" indent="-315602" algn="l" defTabSz="1262407" rtl="0" eaLnBrk="1" latinLnBrk="0" hangingPunct="1">
        <a:lnSpc>
          <a:spcPct val="90000"/>
        </a:lnSpc>
        <a:spcBef>
          <a:spcPts val="690"/>
        </a:spcBef>
        <a:buFont typeface="Arial" panose="020B0604020202020204" pitchFamily="34" charset="0"/>
        <a:buChar char="•"/>
        <a:defRPr sz="3313" kern="1200">
          <a:solidFill>
            <a:schemeClr val="tx1"/>
          </a:solidFill>
          <a:latin typeface="+mn-lt"/>
          <a:ea typeface="+mn-ea"/>
          <a:cs typeface="+mn-cs"/>
        </a:defRPr>
      </a:lvl2pPr>
      <a:lvl3pPr marL="1578009" indent="-315602" algn="l" defTabSz="1262407" rtl="0" eaLnBrk="1" latinLnBrk="0" hangingPunct="1">
        <a:lnSpc>
          <a:spcPct val="90000"/>
        </a:lnSpc>
        <a:spcBef>
          <a:spcPts val="690"/>
        </a:spcBef>
        <a:buFont typeface="Arial" panose="020B0604020202020204" pitchFamily="34" charset="0"/>
        <a:buChar char="•"/>
        <a:defRPr sz="2761" kern="1200">
          <a:solidFill>
            <a:schemeClr val="tx1"/>
          </a:solidFill>
          <a:latin typeface="+mn-lt"/>
          <a:ea typeface="+mn-ea"/>
          <a:cs typeface="+mn-cs"/>
        </a:defRPr>
      </a:lvl3pPr>
      <a:lvl4pPr marL="2209212" indent="-315602" algn="l" defTabSz="1262407" rtl="0" eaLnBrk="1" latinLnBrk="0" hangingPunct="1">
        <a:lnSpc>
          <a:spcPct val="90000"/>
        </a:lnSpc>
        <a:spcBef>
          <a:spcPts val="690"/>
        </a:spcBef>
        <a:buFont typeface="Arial" panose="020B0604020202020204" pitchFamily="34" charset="0"/>
        <a:buChar char="•"/>
        <a:defRPr sz="2485" kern="1200">
          <a:solidFill>
            <a:schemeClr val="tx1"/>
          </a:solidFill>
          <a:latin typeface="+mn-lt"/>
          <a:ea typeface="+mn-ea"/>
          <a:cs typeface="+mn-cs"/>
        </a:defRPr>
      </a:lvl4pPr>
      <a:lvl5pPr marL="2840415" indent="-315602" algn="l" defTabSz="1262407" rtl="0" eaLnBrk="1" latinLnBrk="0" hangingPunct="1">
        <a:lnSpc>
          <a:spcPct val="90000"/>
        </a:lnSpc>
        <a:spcBef>
          <a:spcPts val="690"/>
        </a:spcBef>
        <a:buFont typeface="Arial" panose="020B0604020202020204" pitchFamily="34" charset="0"/>
        <a:buChar char="•"/>
        <a:defRPr sz="2485" kern="1200">
          <a:solidFill>
            <a:schemeClr val="tx1"/>
          </a:solidFill>
          <a:latin typeface="+mn-lt"/>
          <a:ea typeface="+mn-ea"/>
          <a:cs typeface="+mn-cs"/>
        </a:defRPr>
      </a:lvl5pPr>
      <a:lvl6pPr marL="3471619" indent="-315602" algn="l" defTabSz="1262407" rtl="0" eaLnBrk="1" latinLnBrk="0" hangingPunct="1">
        <a:lnSpc>
          <a:spcPct val="90000"/>
        </a:lnSpc>
        <a:spcBef>
          <a:spcPts val="690"/>
        </a:spcBef>
        <a:buFont typeface="Arial" panose="020B0604020202020204" pitchFamily="34" charset="0"/>
        <a:buChar char="•"/>
        <a:defRPr sz="2485" kern="1200">
          <a:solidFill>
            <a:schemeClr val="tx1"/>
          </a:solidFill>
          <a:latin typeface="+mn-lt"/>
          <a:ea typeface="+mn-ea"/>
          <a:cs typeface="+mn-cs"/>
        </a:defRPr>
      </a:lvl6pPr>
      <a:lvl7pPr marL="4102822" indent="-315602" algn="l" defTabSz="1262407" rtl="0" eaLnBrk="1" latinLnBrk="0" hangingPunct="1">
        <a:lnSpc>
          <a:spcPct val="90000"/>
        </a:lnSpc>
        <a:spcBef>
          <a:spcPts val="690"/>
        </a:spcBef>
        <a:buFont typeface="Arial" panose="020B0604020202020204" pitchFamily="34" charset="0"/>
        <a:buChar char="•"/>
        <a:defRPr sz="2485" kern="1200">
          <a:solidFill>
            <a:schemeClr val="tx1"/>
          </a:solidFill>
          <a:latin typeface="+mn-lt"/>
          <a:ea typeface="+mn-ea"/>
          <a:cs typeface="+mn-cs"/>
        </a:defRPr>
      </a:lvl7pPr>
      <a:lvl8pPr marL="4734025" indent="-315602" algn="l" defTabSz="1262407" rtl="0" eaLnBrk="1" latinLnBrk="0" hangingPunct="1">
        <a:lnSpc>
          <a:spcPct val="90000"/>
        </a:lnSpc>
        <a:spcBef>
          <a:spcPts val="690"/>
        </a:spcBef>
        <a:buFont typeface="Arial" panose="020B0604020202020204" pitchFamily="34" charset="0"/>
        <a:buChar char="•"/>
        <a:defRPr sz="2485" kern="1200">
          <a:solidFill>
            <a:schemeClr val="tx1"/>
          </a:solidFill>
          <a:latin typeface="+mn-lt"/>
          <a:ea typeface="+mn-ea"/>
          <a:cs typeface="+mn-cs"/>
        </a:defRPr>
      </a:lvl8pPr>
      <a:lvl9pPr marL="5365229" indent="-315602" algn="l" defTabSz="1262407" rtl="0" eaLnBrk="1" latinLnBrk="0" hangingPunct="1">
        <a:lnSpc>
          <a:spcPct val="90000"/>
        </a:lnSpc>
        <a:spcBef>
          <a:spcPts val="690"/>
        </a:spcBef>
        <a:buFont typeface="Arial" panose="020B0604020202020204" pitchFamily="34" charset="0"/>
        <a:buChar char="•"/>
        <a:defRPr sz="248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62407" rtl="0" eaLnBrk="1" latinLnBrk="0" hangingPunct="1">
        <a:defRPr sz="2485" kern="1200">
          <a:solidFill>
            <a:schemeClr val="tx1"/>
          </a:solidFill>
          <a:latin typeface="+mn-lt"/>
          <a:ea typeface="+mn-ea"/>
          <a:cs typeface="+mn-cs"/>
        </a:defRPr>
      </a:lvl1pPr>
      <a:lvl2pPr marL="631203" algn="l" defTabSz="1262407" rtl="0" eaLnBrk="1" latinLnBrk="0" hangingPunct="1">
        <a:defRPr sz="2485" kern="1200">
          <a:solidFill>
            <a:schemeClr val="tx1"/>
          </a:solidFill>
          <a:latin typeface="+mn-lt"/>
          <a:ea typeface="+mn-ea"/>
          <a:cs typeface="+mn-cs"/>
        </a:defRPr>
      </a:lvl2pPr>
      <a:lvl3pPr marL="1262407" algn="l" defTabSz="1262407" rtl="0" eaLnBrk="1" latinLnBrk="0" hangingPunct="1">
        <a:defRPr sz="2485" kern="1200">
          <a:solidFill>
            <a:schemeClr val="tx1"/>
          </a:solidFill>
          <a:latin typeface="+mn-lt"/>
          <a:ea typeface="+mn-ea"/>
          <a:cs typeface="+mn-cs"/>
        </a:defRPr>
      </a:lvl3pPr>
      <a:lvl4pPr marL="1893610" algn="l" defTabSz="1262407" rtl="0" eaLnBrk="1" latinLnBrk="0" hangingPunct="1">
        <a:defRPr sz="2485" kern="1200">
          <a:solidFill>
            <a:schemeClr val="tx1"/>
          </a:solidFill>
          <a:latin typeface="+mn-lt"/>
          <a:ea typeface="+mn-ea"/>
          <a:cs typeface="+mn-cs"/>
        </a:defRPr>
      </a:lvl4pPr>
      <a:lvl5pPr marL="2524813" algn="l" defTabSz="1262407" rtl="0" eaLnBrk="1" latinLnBrk="0" hangingPunct="1">
        <a:defRPr sz="2485" kern="1200">
          <a:solidFill>
            <a:schemeClr val="tx1"/>
          </a:solidFill>
          <a:latin typeface="+mn-lt"/>
          <a:ea typeface="+mn-ea"/>
          <a:cs typeface="+mn-cs"/>
        </a:defRPr>
      </a:lvl5pPr>
      <a:lvl6pPr marL="3156018" algn="l" defTabSz="1262407" rtl="0" eaLnBrk="1" latinLnBrk="0" hangingPunct="1">
        <a:defRPr sz="2485" kern="1200">
          <a:solidFill>
            <a:schemeClr val="tx1"/>
          </a:solidFill>
          <a:latin typeface="+mn-lt"/>
          <a:ea typeface="+mn-ea"/>
          <a:cs typeface="+mn-cs"/>
        </a:defRPr>
      </a:lvl6pPr>
      <a:lvl7pPr marL="3787221" algn="l" defTabSz="1262407" rtl="0" eaLnBrk="1" latinLnBrk="0" hangingPunct="1">
        <a:defRPr sz="2485" kern="1200">
          <a:solidFill>
            <a:schemeClr val="tx1"/>
          </a:solidFill>
          <a:latin typeface="+mn-lt"/>
          <a:ea typeface="+mn-ea"/>
          <a:cs typeface="+mn-cs"/>
        </a:defRPr>
      </a:lvl7pPr>
      <a:lvl8pPr marL="4418424" algn="l" defTabSz="1262407" rtl="0" eaLnBrk="1" latinLnBrk="0" hangingPunct="1">
        <a:defRPr sz="2485" kern="1200">
          <a:solidFill>
            <a:schemeClr val="tx1"/>
          </a:solidFill>
          <a:latin typeface="+mn-lt"/>
          <a:ea typeface="+mn-ea"/>
          <a:cs typeface="+mn-cs"/>
        </a:defRPr>
      </a:lvl8pPr>
      <a:lvl9pPr marL="5049628" algn="l" defTabSz="1262407" rtl="0" eaLnBrk="1" latinLnBrk="0" hangingPunct="1">
        <a:defRPr sz="248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Başlık 1">
            <a:extLst>
              <a:ext uri="{FF2B5EF4-FFF2-40B4-BE49-F238E27FC236}">
                <a16:creationId xmlns:a16="http://schemas.microsoft.com/office/drawing/2014/main" id="{EA513D34-87ED-AF7F-BD9B-2F60A4DEEBA6}"/>
              </a:ext>
            </a:extLst>
          </p:cNvPr>
          <p:cNvSpPr txBox="1">
            <a:spLocks/>
          </p:cNvSpPr>
          <p:nvPr/>
        </p:nvSpPr>
        <p:spPr>
          <a:xfrm>
            <a:off x="3935391" y="5613756"/>
            <a:ext cx="3495264" cy="82315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vert="horz" lIns="94679" tIns="47339" rIns="94679" bIns="47339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600" dirty="0">
                <a:latin typeface="Aptos" panose="020B0004020202020204" pitchFamily="34" charset="0"/>
              </a:rPr>
              <a:t>Records screened after duplicates were removed</a:t>
            </a:r>
          </a:p>
          <a:p>
            <a:r>
              <a:rPr lang="en-GB" sz="1600" dirty="0">
                <a:latin typeface="Aptos" panose="020B0004020202020204" pitchFamily="34" charset="0"/>
              </a:rPr>
              <a:t>n= </a:t>
            </a:r>
            <a:r>
              <a:rPr lang="en-GB" sz="1600" kern="100" dirty="0">
                <a:latin typeface="Aptos" panose="020B00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4163</a:t>
            </a:r>
            <a:endParaRPr lang="en-GB" sz="1600" dirty="0">
              <a:latin typeface="Aptos" panose="020B0004020202020204" pitchFamily="34" charset="0"/>
            </a:endParaRPr>
          </a:p>
        </p:txBody>
      </p:sp>
      <p:sp>
        <p:nvSpPr>
          <p:cNvPr id="5" name="Başlık 1">
            <a:extLst>
              <a:ext uri="{FF2B5EF4-FFF2-40B4-BE49-F238E27FC236}">
                <a16:creationId xmlns:a16="http://schemas.microsoft.com/office/drawing/2014/main" id="{E5AEB965-E841-8063-B4E2-47E98F92F0FB}"/>
              </a:ext>
            </a:extLst>
          </p:cNvPr>
          <p:cNvSpPr txBox="1">
            <a:spLocks/>
          </p:cNvSpPr>
          <p:nvPr/>
        </p:nvSpPr>
        <p:spPr>
          <a:xfrm>
            <a:off x="8459608" y="4309855"/>
            <a:ext cx="2590052" cy="1221169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vert="horz" lIns="94679" tIns="47339" rIns="94679" bIns="47339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GB" sz="1657" u="sng" dirty="0">
                <a:latin typeface="Aptos" panose="020B0004020202020204" pitchFamily="34" charset="0"/>
              </a:rPr>
              <a:t>Records removed before screening:</a:t>
            </a:r>
          </a:p>
          <a:p>
            <a:pPr lvl="1"/>
            <a:r>
              <a:rPr lang="en-GB" sz="1600" dirty="0">
                <a:latin typeface="Aptos" panose="020B0004020202020204" pitchFamily="34" charset="0"/>
              </a:rPr>
              <a:t>Duplicated records (n= </a:t>
            </a:r>
            <a:r>
              <a:rPr lang="en-GB" sz="1600" kern="100" dirty="0">
                <a:latin typeface="Aptos" panose="020B0004020202020204" pitchFamily="34" charset="0"/>
                <a:cs typeface="Arial" panose="020B0604020202020204" pitchFamily="34" charset="0"/>
              </a:rPr>
              <a:t>71)</a:t>
            </a:r>
          </a:p>
        </p:txBody>
      </p:sp>
      <p:sp>
        <p:nvSpPr>
          <p:cNvPr id="6" name="Başlık 1">
            <a:extLst>
              <a:ext uri="{FF2B5EF4-FFF2-40B4-BE49-F238E27FC236}">
                <a16:creationId xmlns:a16="http://schemas.microsoft.com/office/drawing/2014/main" id="{7F32CDFE-EB59-0769-22ED-28FF95A455EE}"/>
              </a:ext>
            </a:extLst>
          </p:cNvPr>
          <p:cNvSpPr txBox="1">
            <a:spLocks/>
          </p:cNvSpPr>
          <p:nvPr/>
        </p:nvSpPr>
        <p:spPr>
          <a:xfrm>
            <a:off x="8459607" y="6621723"/>
            <a:ext cx="2590052" cy="88060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vert="horz" lIns="94679" tIns="47339" rIns="94679" bIns="47339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>
              <a:lnSpc>
                <a:spcPct val="115000"/>
              </a:lnSpc>
            </a:pPr>
            <a:r>
              <a:rPr lang="en-GB" sz="1657" u="sng" kern="100" dirty="0">
                <a:latin typeface="Aptos" panose="020B00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Records excluded:</a:t>
            </a:r>
            <a:r>
              <a:rPr lang="en-GB" sz="1657" kern="100" dirty="0">
                <a:latin typeface="Aptos" panose="020B00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</a:t>
            </a:r>
          </a:p>
          <a:p>
            <a:pPr>
              <a:lnSpc>
                <a:spcPct val="115000"/>
              </a:lnSpc>
            </a:pPr>
            <a:r>
              <a:rPr lang="en-GB" sz="1657" kern="100" dirty="0">
                <a:latin typeface="Aptos" panose="020B00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Title abstract  (n=4025)</a:t>
            </a:r>
          </a:p>
        </p:txBody>
      </p:sp>
      <p:sp>
        <p:nvSpPr>
          <p:cNvPr id="7" name="Başlık 1">
            <a:extLst>
              <a:ext uri="{FF2B5EF4-FFF2-40B4-BE49-F238E27FC236}">
                <a16:creationId xmlns:a16="http://schemas.microsoft.com/office/drawing/2014/main" id="{B677734E-4964-4F2A-3B3F-04FDFAA64639}"/>
              </a:ext>
            </a:extLst>
          </p:cNvPr>
          <p:cNvSpPr txBox="1">
            <a:spLocks/>
          </p:cNvSpPr>
          <p:nvPr/>
        </p:nvSpPr>
        <p:spPr>
          <a:xfrm>
            <a:off x="3935392" y="7888822"/>
            <a:ext cx="3495263" cy="682518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vert="horz" lIns="94679" tIns="47339" rIns="94679" bIns="47339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>
              <a:lnSpc>
                <a:spcPct val="100000"/>
              </a:lnSpc>
            </a:pPr>
            <a:r>
              <a:rPr lang="en-GB" sz="1657" kern="100" dirty="0">
                <a:latin typeface="Aptos" panose="020B00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Records assessed for eligibility</a:t>
            </a:r>
          </a:p>
          <a:p>
            <a:pPr lvl="0">
              <a:lnSpc>
                <a:spcPct val="100000"/>
              </a:lnSpc>
            </a:pPr>
            <a:r>
              <a:rPr lang="en-GB" sz="1657" kern="100" dirty="0">
                <a:latin typeface="Aptos" panose="020B00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n=138</a:t>
            </a:r>
          </a:p>
        </p:txBody>
      </p:sp>
      <p:sp>
        <p:nvSpPr>
          <p:cNvPr id="8" name="Başlık 1">
            <a:extLst>
              <a:ext uri="{FF2B5EF4-FFF2-40B4-BE49-F238E27FC236}">
                <a16:creationId xmlns:a16="http://schemas.microsoft.com/office/drawing/2014/main" id="{7042FB28-0191-582F-0428-CCBDBE2A13F1}"/>
              </a:ext>
            </a:extLst>
          </p:cNvPr>
          <p:cNvSpPr txBox="1">
            <a:spLocks/>
          </p:cNvSpPr>
          <p:nvPr/>
        </p:nvSpPr>
        <p:spPr>
          <a:xfrm>
            <a:off x="8473057" y="8686232"/>
            <a:ext cx="2590053" cy="164379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vert="horz" lIns="94679" tIns="47339" rIns="94679" bIns="47339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algn="l">
              <a:lnSpc>
                <a:spcPct val="120000"/>
              </a:lnSpc>
            </a:pPr>
            <a:r>
              <a:rPr lang="en-GB" sz="1600" u="sng" kern="100" dirty="0">
                <a:latin typeface="Aptos" panose="020B00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Records excluded:</a:t>
            </a:r>
          </a:p>
          <a:p>
            <a:pPr lvl="1"/>
            <a:r>
              <a:rPr lang="en-GB" sz="1600" kern="100" dirty="0">
                <a:latin typeface="Aptos" panose="020B00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Full text review (n=48)</a:t>
            </a:r>
          </a:p>
          <a:p>
            <a:pPr lvl="1"/>
            <a:r>
              <a:rPr lang="en-GB" sz="1600" kern="100" dirty="0">
                <a:latin typeface="Aptos" panose="020B00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Not conducted in </a:t>
            </a:r>
            <a:r>
              <a:rPr lang="en-GB" sz="1600" kern="100" dirty="0" err="1">
                <a:latin typeface="Aptos" panose="020B00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Türkiye</a:t>
            </a:r>
            <a:r>
              <a:rPr lang="en-GB" sz="1600" kern="100" dirty="0">
                <a:latin typeface="Aptos" panose="020B00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(n=6)</a:t>
            </a:r>
          </a:p>
          <a:p>
            <a:pPr lvl="1"/>
            <a:r>
              <a:rPr lang="en-GB" sz="1600" kern="100" dirty="0">
                <a:latin typeface="Aptos" panose="020B00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Quality assessment (n=11)</a:t>
            </a:r>
          </a:p>
        </p:txBody>
      </p:sp>
      <p:sp>
        <p:nvSpPr>
          <p:cNvPr id="9" name="Başlık 1">
            <a:extLst>
              <a:ext uri="{FF2B5EF4-FFF2-40B4-BE49-F238E27FC236}">
                <a16:creationId xmlns:a16="http://schemas.microsoft.com/office/drawing/2014/main" id="{7F194D48-8841-8AE3-649B-83761F4F1487}"/>
              </a:ext>
            </a:extLst>
          </p:cNvPr>
          <p:cNvSpPr txBox="1">
            <a:spLocks/>
          </p:cNvSpPr>
          <p:nvPr/>
        </p:nvSpPr>
        <p:spPr>
          <a:xfrm>
            <a:off x="3935391" y="10414011"/>
            <a:ext cx="3495263" cy="682518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vert="horz" lIns="94679" tIns="47339" rIns="94679" bIns="47339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>
              <a:lnSpc>
                <a:spcPct val="120000"/>
              </a:lnSpc>
            </a:pPr>
            <a:r>
              <a:rPr lang="en-GB" sz="1657" kern="100" dirty="0">
                <a:latin typeface="Aptos" panose="020B00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Studies included </a:t>
            </a:r>
          </a:p>
          <a:p>
            <a:pPr lvl="0">
              <a:lnSpc>
                <a:spcPct val="120000"/>
              </a:lnSpc>
            </a:pPr>
            <a:r>
              <a:rPr lang="en-GB" sz="1657" kern="100" dirty="0">
                <a:latin typeface="Aptos" panose="020B00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n=73</a:t>
            </a:r>
          </a:p>
        </p:txBody>
      </p:sp>
      <p:sp>
        <p:nvSpPr>
          <p:cNvPr id="11" name="Yuvarlatılmış Dikdörtgen 10">
            <a:extLst>
              <a:ext uri="{FF2B5EF4-FFF2-40B4-BE49-F238E27FC236}">
                <a16:creationId xmlns:a16="http://schemas.microsoft.com/office/drawing/2014/main" id="{B2D2C206-EF3D-3CFA-5A96-3F23629B1735}"/>
              </a:ext>
            </a:extLst>
          </p:cNvPr>
          <p:cNvSpPr/>
          <p:nvPr/>
        </p:nvSpPr>
        <p:spPr>
          <a:xfrm rot="16200000">
            <a:off x="1443660" y="2821671"/>
            <a:ext cx="2492731" cy="939958"/>
          </a:xfrm>
          <a:prstGeom prst="roundRect">
            <a:avLst/>
          </a:prstGeom>
          <a:solidFill>
            <a:schemeClr val="accent1">
              <a:lumMod val="60000"/>
              <a:lumOff val="4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ysClr val="windowText" lastClr="000000"/>
                </a:solidFill>
                <a:latin typeface="Aptos" panose="020B0004020202020204" pitchFamily="34" charset="0"/>
              </a:rPr>
              <a:t>Identification</a:t>
            </a:r>
          </a:p>
        </p:txBody>
      </p:sp>
      <p:sp>
        <p:nvSpPr>
          <p:cNvPr id="12" name="Yuvarlatılmış Dikdörtgen 11">
            <a:extLst>
              <a:ext uri="{FF2B5EF4-FFF2-40B4-BE49-F238E27FC236}">
                <a16:creationId xmlns:a16="http://schemas.microsoft.com/office/drawing/2014/main" id="{985814F7-8AA5-2F43-59E2-A715F574A582}"/>
              </a:ext>
            </a:extLst>
          </p:cNvPr>
          <p:cNvSpPr/>
          <p:nvPr/>
        </p:nvSpPr>
        <p:spPr>
          <a:xfrm rot="16200000">
            <a:off x="414048" y="6732960"/>
            <a:ext cx="4542521" cy="939958"/>
          </a:xfrm>
          <a:prstGeom prst="roundRect">
            <a:avLst/>
          </a:prstGeom>
          <a:solidFill>
            <a:schemeClr val="accent1">
              <a:lumMod val="60000"/>
              <a:lumOff val="4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ysClr val="windowText" lastClr="000000"/>
                </a:solidFill>
                <a:latin typeface="Aptos" panose="020B0004020202020204" pitchFamily="34" charset="0"/>
              </a:rPr>
              <a:t>Screening</a:t>
            </a:r>
            <a:endParaRPr lang="en-GB" sz="1761" b="1" dirty="0">
              <a:solidFill>
                <a:sysClr val="windowText" lastClr="000000"/>
              </a:solidFill>
              <a:latin typeface="Aptos" panose="020B0004020202020204" pitchFamily="34" charset="0"/>
            </a:endParaRPr>
          </a:p>
        </p:txBody>
      </p:sp>
      <p:sp>
        <p:nvSpPr>
          <p:cNvPr id="13" name="Yuvarlatılmış Dikdörtgen 12">
            <a:extLst>
              <a:ext uri="{FF2B5EF4-FFF2-40B4-BE49-F238E27FC236}">
                <a16:creationId xmlns:a16="http://schemas.microsoft.com/office/drawing/2014/main" id="{78B3F6AB-6C87-788A-A57E-A5EE664AF266}"/>
              </a:ext>
            </a:extLst>
          </p:cNvPr>
          <p:cNvSpPr/>
          <p:nvPr/>
        </p:nvSpPr>
        <p:spPr>
          <a:xfrm rot="16200000">
            <a:off x="1943749" y="10243306"/>
            <a:ext cx="1510017" cy="939958"/>
          </a:xfrm>
          <a:prstGeom prst="roundRect">
            <a:avLst/>
          </a:prstGeom>
          <a:solidFill>
            <a:schemeClr val="accent1">
              <a:lumMod val="60000"/>
              <a:lumOff val="4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ysClr val="windowText" lastClr="000000"/>
                </a:solidFill>
                <a:latin typeface="Aptos" panose="020B0004020202020204" pitchFamily="34" charset="0"/>
              </a:rPr>
              <a:t>Included</a:t>
            </a:r>
            <a:endParaRPr lang="en-GB" sz="1761" b="1" dirty="0">
              <a:solidFill>
                <a:sysClr val="windowText" lastClr="000000"/>
              </a:solidFill>
              <a:latin typeface="Aptos" panose="020B0004020202020204" pitchFamily="34" charset="0"/>
            </a:endParaRPr>
          </a:p>
        </p:txBody>
      </p:sp>
      <p:sp>
        <p:nvSpPr>
          <p:cNvPr id="14" name="Yuvarlatılmış Dikdörtgen 13">
            <a:extLst>
              <a:ext uri="{FF2B5EF4-FFF2-40B4-BE49-F238E27FC236}">
                <a16:creationId xmlns:a16="http://schemas.microsoft.com/office/drawing/2014/main" id="{F93E2545-5D7E-0A67-5C62-028C51D2637D}"/>
              </a:ext>
            </a:extLst>
          </p:cNvPr>
          <p:cNvSpPr/>
          <p:nvPr/>
        </p:nvSpPr>
        <p:spPr>
          <a:xfrm>
            <a:off x="2228777" y="862649"/>
            <a:ext cx="7599700" cy="665971"/>
          </a:xfrm>
          <a:prstGeom prst="roundRect">
            <a:avLst/>
          </a:prstGeom>
          <a:solidFill>
            <a:srgbClr val="FFFF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000" b="1" dirty="0">
                <a:solidFill>
                  <a:sysClr val="windowText" lastClr="000000"/>
                </a:solidFill>
                <a:latin typeface="Aptos" panose="020B0004020202020204" pitchFamily="34" charset="0"/>
              </a:rPr>
              <a:t>Flowchart of study review and selection process</a:t>
            </a:r>
          </a:p>
        </p:txBody>
      </p:sp>
      <p:cxnSp>
        <p:nvCxnSpPr>
          <p:cNvPr id="16" name="Düz Ok Bağlayıcısı 15">
            <a:extLst>
              <a:ext uri="{FF2B5EF4-FFF2-40B4-BE49-F238E27FC236}">
                <a16:creationId xmlns:a16="http://schemas.microsoft.com/office/drawing/2014/main" id="{7C57DF06-FB65-598F-987C-6ABED18E899C}"/>
              </a:ext>
            </a:extLst>
          </p:cNvPr>
          <p:cNvCxnSpPr>
            <a:cxnSpLocks/>
            <a:stCxn id="95" idx="2"/>
            <a:endCxn id="4" idx="0"/>
          </p:cNvCxnSpPr>
          <p:nvPr/>
        </p:nvCxnSpPr>
        <p:spPr>
          <a:xfrm>
            <a:off x="5671178" y="4392587"/>
            <a:ext cx="11845" cy="1221169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Düz Ok Bağlayıcısı 18">
            <a:extLst>
              <a:ext uri="{FF2B5EF4-FFF2-40B4-BE49-F238E27FC236}">
                <a16:creationId xmlns:a16="http://schemas.microsoft.com/office/drawing/2014/main" id="{5DFECBB0-E859-84C9-B50A-8426B5FE9D6E}"/>
              </a:ext>
            </a:extLst>
          </p:cNvPr>
          <p:cNvCxnSpPr>
            <a:cxnSpLocks/>
            <a:stCxn id="4" idx="2"/>
            <a:endCxn id="7" idx="0"/>
          </p:cNvCxnSpPr>
          <p:nvPr/>
        </p:nvCxnSpPr>
        <p:spPr>
          <a:xfrm>
            <a:off x="5683023" y="6436906"/>
            <a:ext cx="1" cy="1451916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Düz Ok Bağlayıcısı 19">
            <a:extLst>
              <a:ext uri="{FF2B5EF4-FFF2-40B4-BE49-F238E27FC236}">
                <a16:creationId xmlns:a16="http://schemas.microsoft.com/office/drawing/2014/main" id="{FC8D92C6-62A2-B9F5-D83C-96516591EBAA}"/>
              </a:ext>
            </a:extLst>
          </p:cNvPr>
          <p:cNvCxnSpPr>
            <a:cxnSpLocks/>
            <a:stCxn id="7" idx="2"/>
            <a:endCxn id="9" idx="0"/>
          </p:cNvCxnSpPr>
          <p:nvPr/>
        </p:nvCxnSpPr>
        <p:spPr>
          <a:xfrm flipH="1">
            <a:off x="5683023" y="8571340"/>
            <a:ext cx="1" cy="1842671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Düz Ok Bağlayıcısı 27">
            <a:extLst>
              <a:ext uri="{FF2B5EF4-FFF2-40B4-BE49-F238E27FC236}">
                <a16:creationId xmlns:a16="http://schemas.microsoft.com/office/drawing/2014/main" id="{DA52B9BD-8634-F051-00B2-8520F497E52C}"/>
              </a:ext>
            </a:extLst>
          </p:cNvPr>
          <p:cNvCxnSpPr>
            <a:cxnSpLocks/>
            <a:endCxn id="6" idx="1"/>
          </p:cNvCxnSpPr>
          <p:nvPr/>
        </p:nvCxnSpPr>
        <p:spPr>
          <a:xfrm flipV="1">
            <a:off x="5683023" y="7062026"/>
            <a:ext cx="2776584" cy="3646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Düz Ok Bağlayıcısı 28">
            <a:extLst>
              <a:ext uri="{FF2B5EF4-FFF2-40B4-BE49-F238E27FC236}">
                <a16:creationId xmlns:a16="http://schemas.microsoft.com/office/drawing/2014/main" id="{D8162C3A-8CA5-30BB-3E24-21E9A14F9457}"/>
              </a:ext>
            </a:extLst>
          </p:cNvPr>
          <p:cNvCxnSpPr>
            <a:cxnSpLocks/>
            <a:endCxn id="8" idx="1"/>
          </p:cNvCxnSpPr>
          <p:nvPr/>
        </p:nvCxnSpPr>
        <p:spPr>
          <a:xfrm>
            <a:off x="5689748" y="9508129"/>
            <a:ext cx="2783309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Düz Ok Bağlayıcısı 64">
            <a:extLst>
              <a:ext uri="{FF2B5EF4-FFF2-40B4-BE49-F238E27FC236}">
                <a16:creationId xmlns:a16="http://schemas.microsoft.com/office/drawing/2014/main" id="{C2A71A6C-397F-09AD-2C3A-272BE1393CE1}"/>
              </a:ext>
            </a:extLst>
          </p:cNvPr>
          <p:cNvCxnSpPr>
            <a:cxnSpLocks/>
          </p:cNvCxnSpPr>
          <p:nvPr/>
        </p:nvCxnSpPr>
        <p:spPr>
          <a:xfrm>
            <a:off x="5683023" y="4981103"/>
            <a:ext cx="2776584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Başlık 1">
            <a:extLst>
              <a:ext uri="{FF2B5EF4-FFF2-40B4-BE49-F238E27FC236}">
                <a16:creationId xmlns:a16="http://schemas.microsoft.com/office/drawing/2014/main" id="{75F319EF-9E12-893C-AAF9-04CB8AAD46FB}"/>
              </a:ext>
            </a:extLst>
          </p:cNvPr>
          <p:cNvSpPr txBox="1">
            <a:spLocks/>
          </p:cNvSpPr>
          <p:nvPr/>
        </p:nvSpPr>
        <p:spPr>
          <a:xfrm>
            <a:off x="3911700" y="2045284"/>
            <a:ext cx="3518955" cy="234730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vert="horz" lIns="94679" tIns="47339" rIns="94679" bIns="47339" rtlCol="0" anchor="b">
            <a:normAutofit fontScale="25000" lnSpcReduction="2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>
              <a:defRPr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GB" sz="6400" u="sng" dirty="0">
                <a:latin typeface="Aptos" panose="020B0004020202020204" pitchFamily="34" charset="0"/>
              </a:rPr>
              <a:t>Records identified through databases and open-access journals: </a:t>
            </a:r>
          </a:p>
          <a:p>
            <a:pPr lvl="1">
              <a:spcBef>
                <a:spcPts val="600"/>
              </a:spcBef>
            </a:pPr>
            <a:r>
              <a:rPr lang="en-GB" sz="5600" dirty="0">
                <a:latin typeface="Aptos" panose="020B0004020202020204" pitchFamily="34" charset="0"/>
              </a:rPr>
              <a:t>PubMed (n=1519)</a:t>
            </a:r>
            <a:br>
              <a:rPr lang="en-GB" sz="5600" dirty="0">
                <a:latin typeface="Aptos" panose="020B0004020202020204" pitchFamily="34" charset="0"/>
              </a:rPr>
            </a:br>
            <a:r>
              <a:rPr lang="en-GB" sz="5600" dirty="0">
                <a:latin typeface="Aptos" panose="020B0004020202020204" pitchFamily="34" charset="0"/>
              </a:rPr>
              <a:t>Scopus (n=1180)</a:t>
            </a:r>
            <a:br>
              <a:rPr lang="en-GB" sz="5600" dirty="0">
                <a:latin typeface="Aptos" panose="020B0004020202020204" pitchFamily="34" charset="0"/>
              </a:rPr>
            </a:br>
            <a:r>
              <a:rPr lang="en-GB" sz="5600" dirty="0">
                <a:latin typeface="Aptos" panose="020B0004020202020204" pitchFamily="34" charset="0"/>
              </a:rPr>
              <a:t>Medline Ovid (n=696)</a:t>
            </a:r>
            <a:br>
              <a:rPr lang="en-GB" sz="5600" dirty="0">
                <a:latin typeface="Aptos" panose="020B0004020202020204" pitchFamily="34" charset="0"/>
              </a:rPr>
            </a:br>
            <a:r>
              <a:rPr lang="en-GB" sz="5600" dirty="0">
                <a:latin typeface="Aptos" panose="020B0004020202020204" pitchFamily="34" charset="0"/>
              </a:rPr>
              <a:t>Springer Link (n=327)</a:t>
            </a:r>
            <a:br>
              <a:rPr lang="en-GB" sz="5600" dirty="0">
                <a:latin typeface="Aptos" panose="020B0004020202020204" pitchFamily="34" charset="0"/>
              </a:rPr>
            </a:br>
            <a:r>
              <a:rPr lang="en-GB" sz="5600" dirty="0">
                <a:latin typeface="Aptos" panose="020B0004020202020204" pitchFamily="34" charset="0"/>
              </a:rPr>
              <a:t>ScienceDirect (n=4)</a:t>
            </a:r>
            <a:br>
              <a:rPr lang="en-GB" sz="5600" dirty="0">
                <a:latin typeface="Aptos" panose="020B0004020202020204" pitchFamily="34" charset="0"/>
              </a:rPr>
            </a:br>
            <a:r>
              <a:rPr lang="en-GB" sz="5600" dirty="0">
                <a:latin typeface="Aptos" panose="020B0004020202020204" pitchFamily="34" charset="0"/>
              </a:rPr>
              <a:t>BMJ (n=248)</a:t>
            </a:r>
            <a:br>
              <a:rPr lang="en-GB" sz="5600" dirty="0">
                <a:latin typeface="Aptos" panose="020B0004020202020204" pitchFamily="34" charset="0"/>
              </a:rPr>
            </a:br>
            <a:r>
              <a:rPr lang="en-GB" sz="5600" dirty="0" err="1">
                <a:latin typeface="Aptos" panose="020B0004020202020204" pitchFamily="34" charset="0"/>
              </a:rPr>
              <a:t>PlosOne</a:t>
            </a:r>
            <a:r>
              <a:rPr lang="en-GB" sz="5600" dirty="0">
                <a:latin typeface="Aptos" panose="020B0004020202020204" pitchFamily="34" charset="0"/>
              </a:rPr>
              <a:t> (n=223)</a:t>
            </a:r>
          </a:p>
          <a:p>
            <a:pPr lvl="1"/>
            <a:r>
              <a:rPr lang="en-GB" sz="5600" dirty="0">
                <a:latin typeface="Aptos" panose="020B0004020202020204" pitchFamily="34" charset="0"/>
              </a:rPr>
              <a:t>BMC (n=37)</a:t>
            </a:r>
          </a:p>
          <a:p>
            <a:br>
              <a:rPr lang="en-GB" sz="8700" dirty="0">
                <a:latin typeface="Aptos" panose="020B0004020202020204" pitchFamily="34" charset="0"/>
              </a:rPr>
            </a:br>
            <a:r>
              <a:rPr lang="en-GB" sz="6400" dirty="0">
                <a:latin typeface="Aptos" panose="020B0004020202020204" pitchFamily="34" charset="0"/>
              </a:rPr>
              <a:t>n= 4234</a:t>
            </a:r>
            <a:endParaRPr lang="tr-TR" sz="6400" dirty="0"/>
          </a:p>
        </p:txBody>
      </p:sp>
    </p:spTree>
    <p:extLst>
      <p:ext uri="{BB962C8B-B14F-4D97-AF65-F5344CB8AC3E}">
        <p14:creationId xmlns:p14="http://schemas.microsoft.com/office/powerpoint/2010/main" val="26761135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eması">
  <a:themeElements>
    <a:clrScheme name="Office Teması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eması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eması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eması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011</TotalTime>
  <Words>149</Words>
  <Application>Microsoft Macintosh PowerPoint</Application>
  <PresentationFormat>Özel</PresentationFormat>
  <Paragraphs>23</Paragraphs>
  <Slides>1</Slides>
  <Notes>1</Notes>
  <HiddenSlides>0</HiddenSlides>
  <MMClips>0</MMClips>
  <ScaleCrop>false</ScaleCrop>
  <HeadingPairs>
    <vt:vector size="6" baseType="variant">
      <vt:variant>
        <vt:lpstr>Kullanılan Yazı Tipleri</vt:lpstr>
      </vt:variant>
      <vt:variant>
        <vt:i4>4</vt:i4>
      </vt:variant>
      <vt:variant>
        <vt:lpstr>Tema</vt:lpstr>
      </vt:variant>
      <vt:variant>
        <vt:i4>1</vt:i4>
      </vt:variant>
      <vt:variant>
        <vt:lpstr>Slayt Başlıkları</vt:lpstr>
      </vt:variant>
      <vt:variant>
        <vt:i4>1</vt:i4>
      </vt:variant>
    </vt:vector>
  </HeadingPairs>
  <TitlesOfParts>
    <vt:vector size="6" baseType="lpstr">
      <vt:lpstr>Aptos</vt:lpstr>
      <vt:lpstr>Arial</vt:lpstr>
      <vt:lpstr>Calibri</vt:lpstr>
      <vt:lpstr>Calibri Light</vt:lpstr>
      <vt:lpstr>Office Teması</vt:lpstr>
      <vt:lpstr>PowerPoint Sunusu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ecords identified through databases (PubMed, Medline Ovid, Scopus, ScienceDirect, and Springer Link, BMJ, PlosOne) n= 4166</dc:title>
  <dc:creator>GİZEM GÜLPINAR</dc:creator>
  <cp:lastModifiedBy>GİZEM GÜLPINAR</cp:lastModifiedBy>
  <cp:revision>1</cp:revision>
  <dcterms:created xsi:type="dcterms:W3CDTF">2024-03-30T11:32:04Z</dcterms:created>
  <dcterms:modified xsi:type="dcterms:W3CDTF">2024-04-01T13:45:55Z</dcterms:modified>
</cp:coreProperties>
</file>